
<file path=[Content_Types].xml><?xml version="1.0" encoding="utf-8"?>
<Types xmlns="http://schemas.openxmlformats.org/package/2006/content-types">
  <Default Extension="png" ContentType="image/png"/>
  <Default Extension="tmp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1" r:id="rId2"/>
    <p:sldId id="282" r:id="rId3"/>
    <p:sldId id="283" r:id="rId4"/>
    <p:sldId id="279" r:id="rId5"/>
    <p:sldId id="264" r:id="rId6"/>
    <p:sldId id="288" r:id="rId7"/>
    <p:sldId id="287" r:id="rId8"/>
    <p:sldId id="285" r:id="rId9"/>
    <p:sldId id="286" r:id="rId10"/>
    <p:sldId id="284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92" d="100"/>
          <a:sy n="92" d="100"/>
        </p:scale>
        <p:origin x="9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Pavithra R" userId="bb266ff89db45adc" providerId="LiveId" clId="{8F15DE84-B57D-466E-A00A-E7BE03F8D216}"/>
    <pc:docChg chg="modSld">
      <pc:chgData name="Pavithra R" userId="bb266ff89db45adc" providerId="LiveId" clId="{8F15DE84-B57D-466E-A00A-E7BE03F8D216}" dt="2023-03-20T12:23:31.170" v="0" actId="164"/>
      <pc:docMkLst>
        <pc:docMk/>
      </pc:docMkLst>
      <pc:sldChg chg="addSp modSp">
        <pc:chgData name="Pavithra R" userId="bb266ff89db45adc" providerId="LiveId" clId="{8F15DE84-B57D-466E-A00A-E7BE03F8D216}" dt="2023-03-20T12:23:31.170" v="0" actId="164"/>
        <pc:sldMkLst>
          <pc:docMk/>
          <pc:sldMk cId="1186695766" sldId="283"/>
        </pc:sldMkLst>
        <pc:spChg chg="mod">
          <ac:chgData name="Pavithra R" userId="bb266ff89db45adc" providerId="LiveId" clId="{8F15DE84-B57D-466E-A00A-E7BE03F8D216}" dt="2023-03-20T12:23:31.170" v="0" actId="164"/>
          <ac:spMkLst>
            <pc:docMk/>
            <pc:sldMk cId="1186695766" sldId="283"/>
            <ac:spMk id="4" creationId="{B4B73289-357E-F234-BFEE-A64A2DA4916A}"/>
          </ac:spMkLst>
        </pc:spChg>
        <pc:spChg chg="mod">
          <ac:chgData name="Pavithra R" userId="bb266ff89db45adc" providerId="LiveId" clId="{8F15DE84-B57D-466E-A00A-E7BE03F8D216}" dt="2023-03-20T12:23:31.170" v="0" actId="164"/>
          <ac:spMkLst>
            <pc:docMk/>
            <pc:sldMk cId="1186695766" sldId="283"/>
            <ac:spMk id="5" creationId="{66CBA371-C1C2-3B95-57CB-D6EA57764711}"/>
          </ac:spMkLst>
        </pc:spChg>
        <pc:grpChg chg="add mod">
          <ac:chgData name="Pavithra R" userId="bb266ff89db45adc" providerId="LiveId" clId="{8F15DE84-B57D-466E-A00A-E7BE03F8D216}" dt="2023-03-20T12:23:31.170" v="0" actId="164"/>
          <ac:grpSpMkLst>
            <pc:docMk/>
            <pc:sldMk cId="1186695766" sldId="283"/>
            <ac:grpSpMk id="6" creationId="{5B513FDE-E3FF-85C9-F21F-5B338A501EEA}"/>
          </ac:grpSpMkLst>
        </pc:grpChg>
        <pc:picChg chg="mod">
          <ac:chgData name="Pavithra R" userId="bb266ff89db45adc" providerId="LiveId" clId="{8F15DE84-B57D-466E-A00A-E7BE03F8D216}" dt="2023-03-20T12:23:31.170" v="0" actId="164"/>
          <ac:picMkLst>
            <pc:docMk/>
            <pc:sldMk cId="1186695766" sldId="283"/>
            <ac:picMk id="2" creationId="{F7EF5A52-6E9A-0B0D-6741-5C8F5E4AF453}"/>
          </ac:picMkLst>
        </pc:picChg>
        <pc:picChg chg="mod">
          <ac:chgData name="Pavithra R" userId="bb266ff89db45adc" providerId="LiveId" clId="{8F15DE84-B57D-466E-A00A-E7BE03F8D216}" dt="2023-03-20T12:23:31.170" v="0" actId="164"/>
          <ac:picMkLst>
            <pc:docMk/>
            <pc:sldMk cId="1186695766" sldId="283"/>
            <ac:picMk id="3" creationId="{C07C4571-5D70-61D7-604B-E16C5592B87D}"/>
          </ac:picMkLst>
        </pc:pic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bb266ff89db45adc/Desktop/RT%20PRE%20CALC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bb266ff89db45adc/Desktop/RT%20PRE%20CALC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Data\GROWTH\CELL%20COUNT%201ST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Data\GROWTH\CELL%20COUNT%201ST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JAN%2023%20IMP%20FILES\DATA%20COMPLIE%20THIRD%20YEAR\cell-pigment-spec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JAN%2023%20IMP%20FILES\DATA%20COMPLIE%20THIRD%20YEAR\cell-pigment-spec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JAN%2023%20IMP%20FILES\DATA%20COMPLIE%20THIRD%20YEAR\cell-pigment-spec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JAN%2023%20IMP%20FILES\DATA%20COMPLIE%20THIRD%20YEAR\cell-pigment-spec.xlsx" TargetMode="External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bb266ff89db45adc/Desktop/RT%20PRE%20CALC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bb266ff89db45adc/Desktop/RT%20PRE%20CALC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bb266ff89db45adc/Desktop/RT%20PRE%20CALC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bb266ff89db45adc/Desktop/RT%20PRE%20CALC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bb266ff89db45adc/Desktop/RT%20PRE%20CALC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bb266ff89db45adc/Desktop/RT%20PRE%20CALC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bb266ff89db45adc/Desktop/RT%20PRE%20CALC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bb266ff89db45adc/Desktop/RT%20PRE%20CALC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RT PRE CALC.xlsx]Sheet2'!$O$1</c:f>
              <c:strCache>
                <c:ptCount val="1"/>
                <c:pt idx="0">
                  <c:v>Glutathione reductas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206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6576-4321-911E-B83159B4A289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6576-4321-911E-B83159B4A289}"/>
              </c:ext>
            </c:extLst>
          </c:dPt>
          <c:errBars>
            <c:errBarType val="both"/>
            <c:errValType val="cust"/>
            <c:noEndCap val="0"/>
            <c:plus>
              <c:numRef>
                <c:f>'[RT PRE CALC.xlsx]Sheet2'!$P$2:$P$3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88960228754757187</c:v>
                  </c:pt>
                </c:numCache>
              </c:numRef>
            </c:plus>
            <c:minus>
              <c:numRef>
                <c:f>'[RT PRE CALC.xlsx]Sheet2'!$P$2:$P$3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88960228754757187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RT PRE CALC.xlsx]Sheet2'!$B$2:$B$3</c:f>
              <c:strCache>
                <c:ptCount val="2"/>
                <c:pt idx="0">
                  <c:v>Control</c:v>
                </c:pt>
                <c:pt idx="1">
                  <c:v>Treated</c:v>
                </c:pt>
              </c:strCache>
            </c:strRef>
          </c:cat>
          <c:val>
            <c:numRef>
              <c:f>'[RT PRE CALC.xlsx]Sheet2'!$O$2:$O$3</c:f>
              <c:numCache>
                <c:formatCode>General</c:formatCode>
                <c:ptCount val="2"/>
                <c:pt idx="0">
                  <c:v>1</c:v>
                </c:pt>
                <c:pt idx="1">
                  <c:v>15.8513711935652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6576-4321-911E-B83159B4A28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60534672"/>
        <c:axId val="1160533584"/>
      </c:barChart>
      <c:catAx>
        <c:axId val="11605346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60533584"/>
        <c:crosses val="autoZero"/>
        <c:auto val="1"/>
        <c:lblAlgn val="ctr"/>
        <c:lblOffset val="100"/>
        <c:noMultiLvlLbl val="0"/>
      </c:catAx>
      <c:valAx>
        <c:axId val="116053358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60534672"/>
        <c:crosses val="autoZero"/>
        <c:crossBetween val="between"/>
        <c:majorUnit val="4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2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hytoene desaturase</a:t>
            </a:r>
          </a:p>
        </c:rich>
      </c:tx>
      <c:layout>
        <c:manualLayout>
          <c:xMode val="edge"/>
          <c:yMode val="edge"/>
          <c:x val="0.28696245733788395"/>
          <c:y val="3.797468354430379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0697374432291527"/>
          <c:y val="0.21392405063291137"/>
          <c:w val="0.82476687001155569"/>
          <c:h val="0.6372465862653243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2060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FEEC-4E3E-BD56-BA171FC2CCBA}"/>
              </c:ext>
            </c:extLst>
          </c:dPt>
          <c:errBars>
            <c:errBarType val="both"/>
            <c:errValType val="cust"/>
            <c:noEndCap val="0"/>
            <c:plus>
              <c:numRef>
                <c:f>'[RT PRE CALC.xlsx]Sheet2'!$H$2:$H$3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3834530300259682</c:v>
                  </c:pt>
                </c:numCache>
              </c:numRef>
            </c:plus>
            <c:minus>
              <c:numRef>
                <c:f>'[RT PRE CALC.xlsx]Sheet2'!$H$2:$H$3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3834530300259682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RT PRE CALC.xlsx]Sheet2'!$B$2:$B$3</c:f>
              <c:strCache>
                <c:ptCount val="2"/>
                <c:pt idx="0">
                  <c:v>Control</c:v>
                </c:pt>
                <c:pt idx="1">
                  <c:v>Treated</c:v>
                </c:pt>
              </c:strCache>
            </c:strRef>
          </c:cat>
          <c:val>
            <c:numRef>
              <c:f>'[RT PRE CALC.xlsx]Sheet2'!$G$2:$G$3</c:f>
              <c:numCache>
                <c:formatCode>General</c:formatCode>
                <c:ptCount val="2"/>
                <c:pt idx="0">
                  <c:v>1</c:v>
                </c:pt>
                <c:pt idx="1">
                  <c:v>4.868148218139968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FEEC-4E3E-BD56-BA171FC2CC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60539568"/>
        <c:axId val="1160541744"/>
      </c:barChart>
      <c:catAx>
        <c:axId val="11605395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60541744"/>
        <c:crosses val="autoZero"/>
        <c:auto val="1"/>
        <c:lblAlgn val="ctr"/>
        <c:lblOffset val="100"/>
        <c:noMultiLvlLbl val="0"/>
      </c:catAx>
      <c:valAx>
        <c:axId val="116054174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60539568"/>
        <c:crosses val="autoZero"/>
        <c:crossBetween val="between"/>
        <c:majorUnit val="1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557980764843131"/>
          <c:y val="7.4733367648279148E-2"/>
          <c:w val="0.68470077506247085"/>
          <c:h val="0.79052677854033526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1!$C$19</c:f>
              <c:strCache>
                <c:ptCount val="1"/>
                <c:pt idx="0">
                  <c:v>Control</c:v>
                </c:pt>
              </c:strCache>
            </c:strRef>
          </c:tx>
          <c:spPr>
            <a:ln w="28575" cap="rnd">
              <a:solidFill>
                <a:srgbClr val="00206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1!$C$15:$J$15</c:f>
                <c:numCache>
                  <c:formatCode>General</c:formatCode>
                  <c:ptCount val="8"/>
                  <c:pt idx="0">
                    <c:v>1.1547005383792518E-2</c:v>
                  </c:pt>
                  <c:pt idx="1">
                    <c:v>1.5275252316519465E-2</c:v>
                  </c:pt>
                  <c:pt idx="2">
                    <c:v>3.2145502536643146E-2</c:v>
                  </c:pt>
                  <c:pt idx="3">
                    <c:v>2.5166114784235857E-2</c:v>
                  </c:pt>
                  <c:pt idx="4">
                    <c:v>1.527525231651948E-2</c:v>
                  </c:pt>
                  <c:pt idx="5">
                    <c:v>1.732050807568879E-2</c:v>
                  </c:pt>
                  <c:pt idx="6">
                    <c:v>1.527525231651948E-2</c:v>
                  </c:pt>
                  <c:pt idx="7">
                    <c:v>2.6457513110645928E-2</c:v>
                  </c:pt>
                </c:numCache>
              </c:numRef>
            </c:plus>
            <c:minus>
              <c:numRef>
                <c:f>Sheet1!$C$15:$J$15</c:f>
                <c:numCache>
                  <c:formatCode>General</c:formatCode>
                  <c:ptCount val="8"/>
                  <c:pt idx="0">
                    <c:v>1.1547005383792518E-2</c:v>
                  </c:pt>
                  <c:pt idx="1">
                    <c:v>1.5275252316519465E-2</c:v>
                  </c:pt>
                  <c:pt idx="2">
                    <c:v>3.2145502536643146E-2</c:v>
                  </c:pt>
                  <c:pt idx="3">
                    <c:v>2.5166114784235857E-2</c:v>
                  </c:pt>
                  <c:pt idx="4">
                    <c:v>1.527525231651948E-2</c:v>
                  </c:pt>
                  <c:pt idx="5">
                    <c:v>1.732050807568879E-2</c:v>
                  </c:pt>
                  <c:pt idx="6">
                    <c:v>1.527525231651948E-2</c:v>
                  </c:pt>
                  <c:pt idx="7">
                    <c:v>2.645751311064592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B$20:$B$28</c:f>
              <c:numCache>
                <c:formatCode>General</c:formatCode>
                <c:ptCount val="9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</c:numCache>
            </c:numRef>
          </c:xVal>
          <c:yVal>
            <c:numRef>
              <c:f>Sheet1!$C$20:$C$28</c:f>
              <c:numCache>
                <c:formatCode>General</c:formatCode>
                <c:ptCount val="9"/>
                <c:pt idx="0">
                  <c:v>0.02</c:v>
                </c:pt>
                <c:pt idx="1">
                  <c:v>4.3333333333333335E-2</c:v>
                </c:pt>
                <c:pt idx="2">
                  <c:v>0.18666666666666668</c:v>
                </c:pt>
                <c:pt idx="3">
                  <c:v>0.54333333333333333</c:v>
                </c:pt>
                <c:pt idx="4">
                  <c:v>1.2766666666666666</c:v>
                </c:pt>
                <c:pt idx="5">
                  <c:v>1.6866666666666665</c:v>
                </c:pt>
                <c:pt idx="6">
                  <c:v>1.7299999999999998</c:v>
                </c:pt>
                <c:pt idx="7">
                  <c:v>1.7333333333333334</c:v>
                </c:pt>
                <c:pt idx="8">
                  <c:v>1.7299999999999998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B649-4652-842E-EF01E42FF2C7}"/>
            </c:ext>
          </c:extLst>
        </c:ser>
        <c:ser>
          <c:idx val="1"/>
          <c:order val="1"/>
          <c:tx>
            <c:strRef>
              <c:f>Sheet1!$D$19</c:f>
              <c:strCache>
                <c:ptCount val="1"/>
                <c:pt idx="0">
                  <c:v>2M</c:v>
                </c:pt>
              </c:strCache>
            </c:strRef>
          </c:tx>
          <c:spPr>
            <a:ln w="31750" cap="rnd">
              <a:solidFill>
                <a:schemeClr val="accent6">
                  <a:lumMod val="75000"/>
                </a:schemeClr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1!$C$16:$J$16</c:f>
                <c:numCache>
                  <c:formatCode>General</c:formatCode>
                  <c:ptCount val="8"/>
                  <c:pt idx="0">
                    <c:v>5.773502691896258E-3</c:v>
                  </c:pt>
                  <c:pt idx="1">
                    <c:v>9.999999999999995E-3</c:v>
                  </c:pt>
                  <c:pt idx="2">
                    <c:v>2.5166114784235829E-2</c:v>
                  </c:pt>
                  <c:pt idx="3">
                    <c:v>2.0816659994661344E-2</c:v>
                  </c:pt>
                  <c:pt idx="4">
                    <c:v>2.5166114784235857E-2</c:v>
                  </c:pt>
                  <c:pt idx="5">
                    <c:v>2.0816659994661223E-2</c:v>
                  </c:pt>
                  <c:pt idx="6">
                    <c:v>2.5166114784235857E-2</c:v>
                  </c:pt>
                  <c:pt idx="7">
                    <c:v>2.5166114784235857E-2</c:v>
                  </c:pt>
                </c:numCache>
              </c:numRef>
            </c:plus>
            <c:minus>
              <c:numRef>
                <c:f>Sheet1!$C$16:$J$16</c:f>
                <c:numCache>
                  <c:formatCode>General</c:formatCode>
                  <c:ptCount val="8"/>
                  <c:pt idx="0">
                    <c:v>5.773502691896258E-3</c:v>
                  </c:pt>
                  <c:pt idx="1">
                    <c:v>9.999999999999995E-3</c:v>
                  </c:pt>
                  <c:pt idx="2">
                    <c:v>2.5166114784235829E-2</c:v>
                  </c:pt>
                  <c:pt idx="3">
                    <c:v>2.0816659994661344E-2</c:v>
                  </c:pt>
                  <c:pt idx="4">
                    <c:v>2.5166114784235857E-2</c:v>
                  </c:pt>
                  <c:pt idx="5">
                    <c:v>2.0816659994661223E-2</c:v>
                  </c:pt>
                  <c:pt idx="6">
                    <c:v>2.5166114784235857E-2</c:v>
                  </c:pt>
                  <c:pt idx="7">
                    <c:v>2.516611478423585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B$20:$B$28</c:f>
              <c:numCache>
                <c:formatCode>General</c:formatCode>
                <c:ptCount val="9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</c:numCache>
            </c:numRef>
          </c:xVal>
          <c:yVal>
            <c:numRef>
              <c:f>Sheet1!$D$20:$D$28</c:f>
              <c:numCache>
                <c:formatCode>General</c:formatCode>
                <c:ptCount val="9"/>
                <c:pt idx="0">
                  <c:v>0.02</c:v>
                </c:pt>
                <c:pt idx="1">
                  <c:v>3.3333333333333333E-2</c:v>
                </c:pt>
                <c:pt idx="2">
                  <c:v>0.14000000000000001</c:v>
                </c:pt>
                <c:pt idx="3">
                  <c:v>0.36333333333333329</c:v>
                </c:pt>
                <c:pt idx="4">
                  <c:v>0.8833333333333333</c:v>
                </c:pt>
                <c:pt idx="5">
                  <c:v>1.2533333333333332</c:v>
                </c:pt>
                <c:pt idx="6">
                  <c:v>1.3833333333333335</c:v>
                </c:pt>
                <c:pt idx="7">
                  <c:v>1.4233333333333331</c:v>
                </c:pt>
                <c:pt idx="8">
                  <c:v>1.4233333333333331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B649-4652-842E-EF01E42FF2C7}"/>
            </c:ext>
          </c:extLst>
        </c:ser>
        <c:ser>
          <c:idx val="2"/>
          <c:order val="2"/>
          <c:tx>
            <c:strRef>
              <c:f>Sheet1!$E$19</c:f>
              <c:strCache>
                <c:ptCount val="1"/>
                <c:pt idx="0">
                  <c:v>3M</c:v>
                </c:pt>
              </c:strCache>
            </c:strRef>
          </c:tx>
          <c:spPr>
            <a:ln w="31750" cap="rnd">
              <a:solidFill>
                <a:schemeClr val="tx1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1!$C$17:$J$17</c:f>
                <c:numCache>
                  <c:formatCode>General</c:formatCode>
                  <c:ptCount val="8"/>
                  <c:pt idx="0">
                    <c:v>5.7735026918962398E-3</c:v>
                  </c:pt>
                  <c:pt idx="1">
                    <c:v>1.154700538379248E-2</c:v>
                  </c:pt>
                  <c:pt idx="2">
                    <c:v>2.0816659994661348E-2</c:v>
                  </c:pt>
                  <c:pt idx="3">
                    <c:v>1.732050807568879E-2</c:v>
                  </c:pt>
                  <c:pt idx="4">
                    <c:v>3.0000000000000027E-2</c:v>
                  </c:pt>
                  <c:pt idx="5">
                    <c:v>4.9328828623162457E-2</c:v>
                  </c:pt>
                  <c:pt idx="6">
                    <c:v>9.0737717258774692E-2</c:v>
                  </c:pt>
                  <c:pt idx="7">
                    <c:v>9.6436507609929598E-2</c:v>
                  </c:pt>
                </c:numCache>
              </c:numRef>
            </c:plus>
            <c:minus>
              <c:numRef>
                <c:f>Sheet1!$C$17:$J$17</c:f>
                <c:numCache>
                  <c:formatCode>General</c:formatCode>
                  <c:ptCount val="8"/>
                  <c:pt idx="0">
                    <c:v>5.7735026918962398E-3</c:v>
                  </c:pt>
                  <c:pt idx="1">
                    <c:v>1.154700538379248E-2</c:v>
                  </c:pt>
                  <c:pt idx="2">
                    <c:v>2.0816659994661348E-2</c:v>
                  </c:pt>
                  <c:pt idx="3">
                    <c:v>1.732050807568879E-2</c:v>
                  </c:pt>
                  <c:pt idx="4">
                    <c:v>3.0000000000000027E-2</c:v>
                  </c:pt>
                  <c:pt idx="5">
                    <c:v>4.9328828623162457E-2</c:v>
                  </c:pt>
                  <c:pt idx="6">
                    <c:v>9.0737717258774692E-2</c:v>
                  </c:pt>
                  <c:pt idx="7">
                    <c:v>9.643650760992959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B$20:$B$28</c:f>
              <c:numCache>
                <c:formatCode>General</c:formatCode>
                <c:ptCount val="9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</c:numCache>
            </c:numRef>
          </c:xVal>
          <c:yVal>
            <c:numRef>
              <c:f>Sheet1!$E$20:$E$28</c:f>
              <c:numCache>
                <c:formatCode>General</c:formatCode>
                <c:ptCount val="9"/>
                <c:pt idx="0">
                  <c:v>0.02</c:v>
                </c:pt>
                <c:pt idx="1">
                  <c:v>2.3333333333333334E-2</c:v>
                </c:pt>
                <c:pt idx="2">
                  <c:v>5.3333333333333337E-2</c:v>
                </c:pt>
                <c:pt idx="3">
                  <c:v>0.16666666666666666</c:v>
                </c:pt>
                <c:pt idx="4">
                  <c:v>0.36000000000000004</c:v>
                </c:pt>
                <c:pt idx="5">
                  <c:v>0.72000000000000008</c:v>
                </c:pt>
                <c:pt idx="6">
                  <c:v>0.92333333333333334</c:v>
                </c:pt>
                <c:pt idx="7">
                  <c:v>0.96666666666666679</c:v>
                </c:pt>
                <c:pt idx="8">
                  <c:v>0.98999999999999988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2-B649-4652-842E-EF01E42FF2C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60545552"/>
        <c:axId val="1160540112"/>
      </c:scatterChart>
      <c:valAx>
        <c:axId val="1160545552"/>
        <c:scaling>
          <c:orientation val="minMax"/>
          <c:max val="8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2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s 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rgbClr val="00206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60540112"/>
        <c:crosses val="autoZero"/>
        <c:crossBetween val="midCat"/>
        <c:majorUnit val="1"/>
        <c:minorUnit val="0.4"/>
      </c:valAx>
      <c:valAx>
        <c:axId val="1160540112"/>
        <c:scaling>
          <c:orientation val="minMax"/>
          <c:max val="2.0000000000000102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4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ell number (*10^6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60545552"/>
        <c:crosses val="autoZero"/>
        <c:crossBetween val="midCat"/>
        <c:majorUnit val="0.30000000000000004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81534009571809751"/>
          <c:y val="5.3829175865427625E-2"/>
          <c:w val="0.18197053228262122"/>
          <c:h val="0.1770298897448497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594426326712128"/>
          <c:y val="6.0118305541835323E-2"/>
          <c:w val="0.6575821172356231"/>
          <c:h val="0.81060149670582304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Control</c:v>
                </c:pt>
              </c:strCache>
            </c:strRef>
          </c:tx>
          <c:spPr>
            <a:ln w="31750" cap="rnd">
              <a:solidFill>
                <a:srgbClr val="002060"/>
              </a:solidFill>
              <a:round/>
            </a:ln>
            <a:effectLst/>
          </c:spPr>
          <c:marker>
            <c:symbol val="none"/>
          </c:marker>
          <c:errBars>
            <c:errDir val="x"/>
            <c:errBarType val="both"/>
            <c:errValType val="cust"/>
            <c:noEndCap val="0"/>
            <c:plus>
              <c:numRef>
                <c:f>Sheet1!$C$17:$K$17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5.7735026918962634E-4</c:v>
                  </c:pt>
                  <c:pt idx="2">
                    <c:v>1.1547005383792206E-3</c:v>
                  </c:pt>
                  <c:pt idx="3">
                    <c:v>4.9328828623162518E-3</c:v>
                  </c:pt>
                  <c:pt idx="4">
                    <c:v>2.2188585654190116E-2</c:v>
                  </c:pt>
                  <c:pt idx="5">
                    <c:v>5.5677643628300865E-3</c:v>
                  </c:pt>
                  <c:pt idx="6">
                    <c:v>3.4641016151377583E-3</c:v>
                  </c:pt>
                  <c:pt idx="7">
                    <c:v>5.7735026918962632E-3</c:v>
                  </c:pt>
                  <c:pt idx="8">
                    <c:v>5.50757054728608E-3</c:v>
                  </c:pt>
                </c:numCache>
              </c:numRef>
            </c:plus>
            <c:minus>
              <c:numRef>
                <c:f>Sheet1!$C$17:$K$17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5.7735026918962634E-4</c:v>
                  </c:pt>
                  <c:pt idx="2">
                    <c:v>1.1547005383792206E-3</c:v>
                  </c:pt>
                  <c:pt idx="3">
                    <c:v>4.9328828623162518E-3</c:v>
                  </c:pt>
                  <c:pt idx="4">
                    <c:v>2.2188585654190116E-2</c:v>
                  </c:pt>
                  <c:pt idx="5">
                    <c:v>5.5677643628300865E-3</c:v>
                  </c:pt>
                  <c:pt idx="6">
                    <c:v>3.4641016151377583E-3</c:v>
                  </c:pt>
                  <c:pt idx="7">
                    <c:v>5.7735026918962632E-3</c:v>
                  </c:pt>
                  <c:pt idx="8">
                    <c:v>5.50757054728608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y"/>
            <c:errBarType val="both"/>
            <c:errValType val="cust"/>
            <c:noEndCap val="0"/>
            <c:plus>
              <c:numRef>
                <c:f>Sheet1!$C$17:$K$17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5.7735026918962634E-4</c:v>
                  </c:pt>
                  <c:pt idx="2">
                    <c:v>1.1547005383792206E-3</c:v>
                  </c:pt>
                  <c:pt idx="3">
                    <c:v>4.9328828623162518E-3</c:v>
                  </c:pt>
                  <c:pt idx="4">
                    <c:v>2.2188585654190116E-2</c:v>
                  </c:pt>
                  <c:pt idx="5">
                    <c:v>5.5677643628300865E-3</c:v>
                  </c:pt>
                  <c:pt idx="6">
                    <c:v>3.4641016151377583E-3</c:v>
                  </c:pt>
                  <c:pt idx="7">
                    <c:v>5.7735026918962632E-3</c:v>
                  </c:pt>
                  <c:pt idx="8">
                    <c:v>5.50757054728608E-3</c:v>
                  </c:pt>
                </c:numCache>
              </c:numRef>
            </c:plus>
            <c:minus>
              <c:numRef>
                <c:f>Sheet1!$C$17:$K$17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5.7735026918962634E-4</c:v>
                  </c:pt>
                  <c:pt idx="2">
                    <c:v>1.1547005383792206E-3</c:v>
                  </c:pt>
                  <c:pt idx="3">
                    <c:v>4.9328828623162518E-3</c:v>
                  </c:pt>
                  <c:pt idx="4">
                    <c:v>2.2188585654190116E-2</c:v>
                  </c:pt>
                  <c:pt idx="5">
                    <c:v>5.5677643628300865E-3</c:v>
                  </c:pt>
                  <c:pt idx="6">
                    <c:v>3.4641016151377583E-3</c:v>
                  </c:pt>
                  <c:pt idx="7">
                    <c:v>5.7735026918962632E-3</c:v>
                  </c:pt>
                  <c:pt idx="8">
                    <c:v>5.50757054728608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A$2:$A$10</c:f>
              <c:numCache>
                <c:formatCode>General</c:formatCode>
                <c:ptCount val="9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</c:numCache>
            </c:numRef>
          </c:xVal>
          <c:yVal>
            <c:numRef>
              <c:f>Sheet1!$B$2:$B$10</c:f>
              <c:numCache>
                <c:formatCode>General</c:formatCode>
                <c:ptCount val="9"/>
                <c:pt idx="0">
                  <c:v>0.1</c:v>
                </c:pt>
                <c:pt idx="1">
                  <c:v>0.192</c:v>
                </c:pt>
                <c:pt idx="2">
                  <c:v>0.34300000000000003</c:v>
                </c:pt>
                <c:pt idx="3">
                  <c:v>0.76400000000000001</c:v>
                </c:pt>
                <c:pt idx="4">
                  <c:v>1.121</c:v>
                </c:pt>
                <c:pt idx="5">
                  <c:v>1.2210000000000001</c:v>
                </c:pt>
                <c:pt idx="6">
                  <c:v>1.2290000000000001</c:v>
                </c:pt>
                <c:pt idx="7">
                  <c:v>1.23</c:v>
                </c:pt>
                <c:pt idx="8">
                  <c:v>1.23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F356-4D14-8201-6F85A9A79A09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2M</c:v>
                </c:pt>
              </c:strCache>
            </c:strRef>
          </c:tx>
          <c:spPr>
            <a:ln w="31750" cap="rnd">
              <a:solidFill>
                <a:schemeClr val="accent6">
                  <a:lumMod val="75000"/>
                </a:schemeClr>
              </a:solidFill>
              <a:round/>
            </a:ln>
            <a:effectLst/>
          </c:spPr>
          <c:marker>
            <c:symbol val="none"/>
          </c:marker>
          <c:errBars>
            <c:errDir val="x"/>
            <c:errBarType val="both"/>
            <c:errValType val="cust"/>
            <c:noEndCap val="0"/>
            <c:plus>
              <c:numRef>
                <c:f>Sheet1!$C$21:$K$21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5.5075705472861069E-3</c:v>
                  </c:pt>
                  <c:pt idx="2">
                    <c:v>5.7735026918962634E-4</c:v>
                  </c:pt>
                  <c:pt idx="3">
                    <c:v>6.8068592855540519E-3</c:v>
                  </c:pt>
                  <c:pt idx="4">
                    <c:v>1.7320508075688791E-3</c:v>
                  </c:pt>
                  <c:pt idx="5">
                    <c:v>6.5574385243020571E-3</c:v>
                  </c:pt>
                  <c:pt idx="6">
                    <c:v>1.5275252316519965E-3</c:v>
                  </c:pt>
                  <c:pt idx="7">
                    <c:v>1.1547005383792527E-3</c:v>
                  </c:pt>
                  <c:pt idx="8">
                    <c:v>1.0000000000000009E-2</c:v>
                  </c:pt>
                </c:numCache>
              </c:numRef>
            </c:plus>
            <c:minus>
              <c:numRef>
                <c:f>Sheet1!$C$21:$K$21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5.5075705472861069E-3</c:v>
                  </c:pt>
                  <c:pt idx="2">
                    <c:v>5.7735026918962634E-4</c:v>
                  </c:pt>
                  <c:pt idx="3">
                    <c:v>6.8068592855540519E-3</c:v>
                  </c:pt>
                  <c:pt idx="4">
                    <c:v>1.7320508075688791E-3</c:v>
                  </c:pt>
                  <c:pt idx="5">
                    <c:v>6.5574385243020571E-3</c:v>
                  </c:pt>
                  <c:pt idx="6">
                    <c:v>1.5275252316519965E-3</c:v>
                  </c:pt>
                  <c:pt idx="7">
                    <c:v>1.1547005383792527E-3</c:v>
                  </c:pt>
                  <c:pt idx="8">
                    <c:v>1.000000000000000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A$2:$A$10</c:f>
              <c:numCache>
                <c:formatCode>General</c:formatCode>
                <c:ptCount val="9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</c:numCache>
            </c:numRef>
          </c:xVal>
          <c:yVal>
            <c:numRef>
              <c:f>Sheet1!$C$2:$C$10</c:f>
              <c:numCache>
                <c:formatCode>General</c:formatCode>
                <c:ptCount val="9"/>
                <c:pt idx="0">
                  <c:v>0.1</c:v>
                </c:pt>
                <c:pt idx="1">
                  <c:v>0.14899999999999999</c:v>
                </c:pt>
                <c:pt idx="2">
                  <c:v>0.255</c:v>
                </c:pt>
                <c:pt idx="3">
                  <c:v>0.52100000000000002</c:v>
                </c:pt>
                <c:pt idx="4">
                  <c:v>0.88300000000000001</c:v>
                </c:pt>
                <c:pt idx="5">
                  <c:v>1.0289999999999999</c:v>
                </c:pt>
                <c:pt idx="6">
                  <c:v>1.0649999999999999</c:v>
                </c:pt>
                <c:pt idx="7">
                  <c:v>1.097</c:v>
                </c:pt>
                <c:pt idx="8">
                  <c:v>1.1000000000000001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F356-4D14-8201-6F85A9A79A09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3M</c:v>
                </c:pt>
              </c:strCache>
            </c:strRef>
          </c:tx>
          <c:spPr>
            <a:ln w="31750" cap="rnd">
              <a:solidFill>
                <a:schemeClr val="tx1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none"/>
          </c:marker>
          <c:errBars>
            <c:errDir val="x"/>
            <c:errBarType val="both"/>
            <c:errValType val="cust"/>
            <c:noEndCap val="0"/>
            <c:plus>
              <c:numRef>
                <c:f>Sheet1!$C$25:$K$25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1.7320508075688709E-3</c:v>
                  </c:pt>
                  <c:pt idx="2">
                    <c:v>1.0000000000000009E-3</c:v>
                  </c:pt>
                  <c:pt idx="3">
                    <c:v>8.0829037686547672E-3</c:v>
                  </c:pt>
                  <c:pt idx="4">
                    <c:v>2.0000000000000018E-3</c:v>
                  </c:pt>
                  <c:pt idx="5">
                    <c:v>3.4641016151377574E-3</c:v>
                  </c:pt>
                  <c:pt idx="6">
                    <c:v>2.0816659994661348E-3</c:v>
                  </c:pt>
                  <c:pt idx="7">
                    <c:v>4.0414518843273836E-3</c:v>
                  </c:pt>
                  <c:pt idx="8">
                    <c:v>2.0000000000000018E-2</c:v>
                  </c:pt>
                </c:numCache>
              </c:numRef>
            </c:plus>
            <c:minus>
              <c:numRef>
                <c:f>Sheet1!$C$25:$K$25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1.7320508075688709E-3</c:v>
                  </c:pt>
                  <c:pt idx="2">
                    <c:v>1.0000000000000009E-3</c:v>
                  </c:pt>
                  <c:pt idx="3">
                    <c:v>8.0829037686547672E-3</c:v>
                  </c:pt>
                  <c:pt idx="4">
                    <c:v>2.0000000000000018E-3</c:v>
                  </c:pt>
                  <c:pt idx="5">
                    <c:v>3.4641016151377574E-3</c:v>
                  </c:pt>
                  <c:pt idx="6">
                    <c:v>2.0816659994661348E-3</c:v>
                  </c:pt>
                  <c:pt idx="7">
                    <c:v>4.0414518843273836E-3</c:v>
                  </c:pt>
                  <c:pt idx="8">
                    <c:v>2.000000000000001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A$2:$A$10</c:f>
              <c:numCache>
                <c:formatCode>General</c:formatCode>
                <c:ptCount val="9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</c:numCache>
            </c:numRef>
          </c:xVal>
          <c:yVal>
            <c:numRef>
              <c:f>Sheet1!$D$2:$D$10</c:f>
              <c:numCache>
                <c:formatCode>General</c:formatCode>
                <c:ptCount val="9"/>
                <c:pt idx="0">
                  <c:v>0.1</c:v>
                </c:pt>
                <c:pt idx="1">
                  <c:v>0.11799999999999999</c:v>
                </c:pt>
                <c:pt idx="2">
                  <c:v>0.18</c:v>
                </c:pt>
                <c:pt idx="3">
                  <c:v>0.30399999999999999</c:v>
                </c:pt>
                <c:pt idx="4">
                  <c:v>0.49299999999999999</c:v>
                </c:pt>
                <c:pt idx="5">
                  <c:v>0.71799999999999997</c:v>
                </c:pt>
                <c:pt idx="6">
                  <c:v>0.79400000000000004</c:v>
                </c:pt>
                <c:pt idx="7">
                  <c:v>0.83199999999999996</c:v>
                </c:pt>
                <c:pt idx="8">
                  <c:v>0.87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2-F356-4D14-8201-6F85A9A79A0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60540656"/>
        <c:axId val="1160541200"/>
      </c:scatterChart>
      <c:valAx>
        <c:axId val="1160540656"/>
        <c:scaling>
          <c:orientation val="minMax"/>
          <c:max val="8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200" b="1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60541200"/>
        <c:crosses val="autoZero"/>
        <c:crossBetween val="midCat"/>
        <c:majorUnit val="1"/>
      </c:valAx>
      <c:valAx>
        <c:axId val="116054120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400" b="1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ptical density (730nm)</a:t>
                </a:r>
              </a:p>
            </c:rich>
          </c:tx>
          <c:layout>
            <c:manualLayout>
              <c:xMode val="edge"/>
              <c:yMode val="edge"/>
              <c:x val="3.4315573249756467E-2"/>
              <c:y val="0.194622054088023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60540656"/>
        <c:crosses val="autoZero"/>
        <c:crossBetween val="midCat"/>
      </c:valAx>
      <c:spPr>
        <a:noFill/>
        <a:ln w="25400">
          <a:noFill/>
        </a:ln>
        <a:effectLst/>
      </c:spPr>
    </c:plotArea>
    <c:legend>
      <c:legendPos val="r"/>
      <c:layout>
        <c:manualLayout>
          <c:xMode val="edge"/>
          <c:yMode val="edge"/>
          <c:x val="0.81793451451394039"/>
          <c:y val="5.3485023334459834E-2"/>
          <c:w val="0.18206548548605969"/>
          <c:h val="0.1854004496220936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6350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832031465180076"/>
          <c:y val="4.9484185618227754E-2"/>
          <c:w val="0.807383961131248"/>
          <c:h val="0.8361225320142190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H$40</c:f>
              <c:strCache>
                <c:ptCount val="1"/>
                <c:pt idx="0">
                  <c:v>Dry weight in biomass(mg/L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206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4501-41C7-8A2B-377B4B691F9C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6">
                  <a:lumMod val="75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4501-41C7-8A2B-377B4B691F9C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4501-41C7-8A2B-377B4B691F9C}"/>
              </c:ext>
            </c:extLst>
          </c:dPt>
          <c:errBars>
            <c:errBarType val="both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G$41:$G$43</c:f>
              <c:strCache>
                <c:ptCount val="3"/>
                <c:pt idx="0">
                  <c:v>Control</c:v>
                </c:pt>
                <c:pt idx="1">
                  <c:v>2M</c:v>
                </c:pt>
                <c:pt idx="2">
                  <c:v>3M</c:v>
                </c:pt>
              </c:strCache>
            </c:strRef>
          </c:cat>
          <c:val>
            <c:numRef>
              <c:f>Sheet1!$H$41:$H$43</c:f>
              <c:numCache>
                <c:formatCode>General</c:formatCode>
                <c:ptCount val="3"/>
                <c:pt idx="0">
                  <c:v>53.285166666666669</c:v>
                </c:pt>
                <c:pt idx="1">
                  <c:v>45.300000000000004</c:v>
                </c:pt>
                <c:pt idx="2">
                  <c:v>27.96666666666666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4501-41C7-8A2B-377B4B691F9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17762608"/>
        <c:axId val="1117763696"/>
      </c:barChart>
      <c:catAx>
        <c:axId val="11177626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17763696"/>
        <c:crosses val="autoZero"/>
        <c:auto val="1"/>
        <c:lblAlgn val="ctr"/>
        <c:lblOffset val="100"/>
        <c:noMultiLvlLbl val="0"/>
      </c:catAx>
      <c:valAx>
        <c:axId val="111776369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GB" sz="14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ry weight in biomas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177626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2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lorophyll a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K$4</c:f>
              <c:strCache>
                <c:ptCount val="1"/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206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E32C-4C67-BFE5-942A599969EC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6">
                  <a:lumMod val="5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E32C-4C67-BFE5-942A599969EC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>
                  <a:lumMod val="65000"/>
                  <a:lumOff val="35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E32C-4C67-BFE5-942A599969EC}"/>
              </c:ext>
            </c:extLst>
          </c:dPt>
          <c:errBars>
            <c:errBarType val="both"/>
            <c:errValType val="cust"/>
            <c:noEndCap val="0"/>
            <c:plus>
              <c:numRef>
                <c:f>Sheet2!$L$5:$L$7</c:f>
                <c:numCache>
                  <c:formatCode>General</c:formatCode>
                  <c:ptCount val="3"/>
                  <c:pt idx="0">
                    <c:v>9.7400995203675969E-2</c:v>
                  </c:pt>
                  <c:pt idx="1">
                    <c:v>0.10161704067505366</c:v>
                  </c:pt>
                  <c:pt idx="2">
                    <c:v>6.7745961421245532E-2</c:v>
                  </c:pt>
                </c:numCache>
              </c:numRef>
            </c:plus>
            <c:minus>
              <c:numRef>
                <c:f>Sheet2!$L$5:$L$7</c:f>
                <c:numCache>
                  <c:formatCode>General</c:formatCode>
                  <c:ptCount val="3"/>
                  <c:pt idx="0">
                    <c:v>9.7400995203675969E-2</c:v>
                  </c:pt>
                  <c:pt idx="1">
                    <c:v>0.10161704067505366</c:v>
                  </c:pt>
                  <c:pt idx="2">
                    <c:v>6.7745961421245532E-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2!$J$5:$J$7</c:f>
              <c:strCache>
                <c:ptCount val="3"/>
                <c:pt idx="0">
                  <c:v>Control</c:v>
                </c:pt>
                <c:pt idx="1">
                  <c:v>2M</c:v>
                </c:pt>
                <c:pt idx="2">
                  <c:v>3M</c:v>
                </c:pt>
              </c:strCache>
            </c:strRef>
          </c:cat>
          <c:val>
            <c:numRef>
              <c:f>Sheet2!$K$5:$K$7</c:f>
              <c:numCache>
                <c:formatCode>General</c:formatCode>
                <c:ptCount val="3"/>
                <c:pt idx="0">
                  <c:v>9.5202899999999975</c:v>
                </c:pt>
                <c:pt idx="1">
                  <c:v>8.9012833333333337</c:v>
                </c:pt>
                <c:pt idx="2">
                  <c:v>8.398663333333331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E32C-4C67-BFE5-942A599969E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90100064"/>
        <c:axId val="1195892544"/>
      </c:barChart>
      <c:catAx>
        <c:axId val="8901000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95892544"/>
        <c:crosses val="autoZero"/>
        <c:auto val="1"/>
        <c:lblAlgn val="ctr"/>
        <c:lblOffset val="100"/>
        <c:noMultiLvlLbl val="0"/>
      </c:catAx>
      <c:valAx>
        <c:axId val="1195892544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GB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</a:t>
                </a:r>
                <a:r>
                  <a:rPr lang="en-GB" b="1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amount </a:t>
                </a:r>
                <a:r>
                  <a:rPr lang="en-US" sz="1000" b="1" i="0" u="none" strike="noStrike" baseline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µg/3*10</a:t>
                </a:r>
                <a:r>
                  <a:rPr lang="en-US" sz="1000" b="1" i="0" u="none" strike="noStrike" baseline="3000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 </a:t>
                </a:r>
                <a:r>
                  <a:rPr lang="en-US" sz="1000" b="1" i="0" u="none" strike="noStrike" baseline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Cells) </a:t>
                </a:r>
                <a:endParaRPr lang="en-GB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8901000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2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lorophyll b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N$4</c:f>
              <c:strCache>
                <c:ptCount val="1"/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206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F670-47EC-8FEB-E8AA25EA3407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6">
                  <a:lumMod val="5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F670-47EC-8FEB-E8AA25EA3407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>
                  <a:lumMod val="65000"/>
                  <a:lumOff val="35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F670-47EC-8FEB-E8AA25EA3407}"/>
              </c:ext>
            </c:extLst>
          </c:dPt>
          <c:errBars>
            <c:errBarType val="both"/>
            <c:errValType val="cust"/>
            <c:noEndCap val="0"/>
            <c:plus>
              <c:numRef>
                <c:f>Sheet2!$O$5:$O$7</c:f>
                <c:numCache>
                  <c:formatCode>General</c:formatCode>
                  <c:ptCount val="3"/>
                  <c:pt idx="0">
                    <c:v>4.8435142430080756E-2</c:v>
                  </c:pt>
                  <c:pt idx="1">
                    <c:v>2.8602807942966324E-2</c:v>
                  </c:pt>
                  <c:pt idx="2">
                    <c:v>0.1006817948897528</c:v>
                  </c:pt>
                </c:numCache>
              </c:numRef>
            </c:plus>
            <c:minus>
              <c:numRef>
                <c:f>Sheet2!$O$5:$O$7</c:f>
                <c:numCache>
                  <c:formatCode>General</c:formatCode>
                  <c:ptCount val="3"/>
                  <c:pt idx="0">
                    <c:v>4.8435142430080756E-2</c:v>
                  </c:pt>
                  <c:pt idx="1">
                    <c:v>2.8602807942966324E-2</c:v>
                  </c:pt>
                  <c:pt idx="2">
                    <c:v>0.1006817948897528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2!$M$5:$M$7</c:f>
              <c:strCache>
                <c:ptCount val="3"/>
                <c:pt idx="0">
                  <c:v>Control</c:v>
                </c:pt>
                <c:pt idx="1">
                  <c:v>2M</c:v>
                </c:pt>
                <c:pt idx="2">
                  <c:v>3M</c:v>
                </c:pt>
              </c:strCache>
            </c:strRef>
          </c:cat>
          <c:val>
            <c:numRef>
              <c:f>Sheet2!$N$5:$N$7</c:f>
              <c:numCache>
                <c:formatCode>General</c:formatCode>
                <c:ptCount val="3"/>
                <c:pt idx="0">
                  <c:v>3.1154733333333327</c:v>
                </c:pt>
                <c:pt idx="1">
                  <c:v>3.1098866666666662</c:v>
                </c:pt>
                <c:pt idx="2">
                  <c:v>3.251286666666665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F670-47EC-8FEB-E8AA25EA340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95884384"/>
        <c:axId val="1195893088"/>
      </c:barChart>
      <c:catAx>
        <c:axId val="11958843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95893088"/>
        <c:crosses val="autoZero"/>
        <c:auto val="1"/>
        <c:lblAlgn val="ctr"/>
        <c:lblOffset val="100"/>
        <c:noMultiLvlLbl val="0"/>
      </c:catAx>
      <c:valAx>
        <c:axId val="1195893088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GB" sz="1000" b="1" i="0" baseline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amount </a:t>
                </a:r>
                <a:r>
                  <a:rPr lang="en-US" sz="1000" b="1" i="0" baseline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µg/3*10</a:t>
                </a:r>
                <a:r>
                  <a:rPr lang="en-US" sz="1000" b="1" i="0" baseline="3000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 </a:t>
                </a:r>
                <a:r>
                  <a:rPr lang="en-US" sz="1000" b="1" i="0" baseline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Cells) </a:t>
                </a:r>
                <a:endParaRPr lang="en-GB" sz="1000"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958843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2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la/b ratio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Q$4</c:f>
              <c:strCache>
                <c:ptCount val="1"/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206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BC66-49B4-B1B8-736E3439C7ED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6">
                  <a:lumMod val="5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BC66-49B4-B1B8-736E3439C7ED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>
                  <a:lumMod val="65000"/>
                  <a:lumOff val="35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BC66-49B4-B1B8-736E3439C7ED}"/>
              </c:ext>
            </c:extLst>
          </c:dPt>
          <c:errBars>
            <c:errBarType val="both"/>
            <c:errValType val="cust"/>
            <c:noEndCap val="0"/>
            <c:plus>
              <c:numRef>
                <c:f>Sheet2!$R$5:$R$7</c:f>
                <c:numCache>
                  <c:formatCode>General</c:formatCode>
                  <c:ptCount val="3"/>
                  <c:pt idx="0">
                    <c:v>7.6635516487897057E-2</c:v>
                  </c:pt>
                  <c:pt idx="1">
                    <c:v>4.9476983405190404E-2</c:v>
                  </c:pt>
                  <c:pt idx="2">
                    <c:v>5.8915110402645715E-2</c:v>
                  </c:pt>
                </c:numCache>
              </c:numRef>
            </c:plus>
            <c:minus>
              <c:numRef>
                <c:f>Sheet2!$R$5:$R$7</c:f>
                <c:numCache>
                  <c:formatCode>General</c:formatCode>
                  <c:ptCount val="3"/>
                  <c:pt idx="0">
                    <c:v>7.6635516487897057E-2</c:v>
                  </c:pt>
                  <c:pt idx="1">
                    <c:v>4.9476983405190404E-2</c:v>
                  </c:pt>
                  <c:pt idx="2">
                    <c:v>5.8915110402645715E-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2!$P$5:$P$7</c:f>
              <c:strCache>
                <c:ptCount val="3"/>
                <c:pt idx="0">
                  <c:v>Control</c:v>
                </c:pt>
                <c:pt idx="1">
                  <c:v>2M</c:v>
                </c:pt>
                <c:pt idx="2">
                  <c:v>3M</c:v>
                </c:pt>
              </c:strCache>
            </c:strRef>
          </c:cat>
          <c:val>
            <c:numRef>
              <c:f>Sheet2!$Q$5:$Q$7</c:f>
              <c:numCache>
                <c:formatCode>General</c:formatCode>
                <c:ptCount val="3"/>
                <c:pt idx="0">
                  <c:v>3.0569865414808519</c:v>
                </c:pt>
                <c:pt idx="1">
                  <c:v>2.8626151980649248</c:v>
                </c:pt>
                <c:pt idx="2">
                  <c:v>2.585005612153880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BC66-49B4-B1B8-736E3439C7E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95880576"/>
        <c:axId val="1195882208"/>
      </c:barChart>
      <c:catAx>
        <c:axId val="11958805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95882208"/>
        <c:crosses val="autoZero"/>
        <c:auto val="1"/>
        <c:lblAlgn val="ctr"/>
        <c:lblOffset val="100"/>
        <c:noMultiLvlLbl val="0"/>
      </c:catAx>
      <c:valAx>
        <c:axId val="1195882208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000" b="1" i="0" baseline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hla/b  </a:t>
                </a:r>
                <a:endParaRPr lang="en-GB" sz="1000" b="1"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958805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2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tal Carotenoid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T$4</c:f>
              <c:strCache>
                <c:ptCount val="1"/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206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40B4-46B4-887E-B33925325F57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6">
                  <a:lumMod val="5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40B4-46B4-887E-B33925325F57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>
                  <a:lumMod val="65000"/>
                  <a:lumOff val="35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40B4-46B4-887E-B33925325F57}"/>
              </c:ext>
            </c:extLst>
          </c:dPt>
          <c:errBars>
            <c:errBarType val="both"/>
            <c:errValType val="cust"/>
            <c:noEndCap val="0"/>
            <c:plus>
              <c:numRef>
                <c:f>Sheet2!$U$5:$U$7</c:f>
                <c:numCache>
                  <c:formatCode>General</c:formatCode>
                  <c:ptCount val="3"/>
                  <c:pt idx="0">
                    <c:v>9.1689960676666598E-4</c:v>
                  </c:pt>
                  <c:pt idx="1">
                    <c:v>7.8540859854388748E-3</c:v>
                  </c:pt>
                  <c:pt idx="2">
                    <c:v>5.2821991211573988E-3</c:v>
                  </c:pt>
                </c:numCache>
              </c:numRef>
            </c:plus>
            <c:minus>
              <c:numRef>
                <c:f>Sheet2!$U$5:$U$7</c:f>
                <c:numCache>
                  <c:formatCode>General</c:formatCode>
                  <c:ptCount val="3"/>
                  <c:pt idx="0">
                    <c:v>9.1689960676666598E-4</c:v>
                  </c:pt>
                  <c:pt idx="1">
                    <c:v>7.8540859854388748E-3</c:v>
                  </c:pt>
                  <c:pt idx="2">
                    <c:v>5.2821991211573988E-3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2!$S$5:$S$7</c:f>
              <c:strCache>
                <c:ptCount val="3"/>
                <c:pt idx="0">
                  <c:v>Control</c:v>
                </c:pt>
                <c:pt idx="1">
                  <c:v>2M</c:v>
                </c:pt>
                <c:pt idx="2">
                  <c:v>3M</c:v>
                </c:pt>
              </c:strCache>
            </c:strRef>
          </c:cat>
          <c:val>
            <c:numRef>
              <c:f>Sheet2!$T$5:$T$7</c:f>
              <c:numCache>
                <c:formatCode>General</c:formatCode>
                <c:ptCount val="3"/>
                <c:pt idx="0">
                  <c:v>0.78386933333333342</c:v>
                </c:pt>
                <c:pt idx="1">
                  <c:v>0.847194</c:v>
                </c:pt>
                <c:pt idx="2">
                  <c:v>1.056576666666666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40B4-46B4-887E-B33925325F5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95886560"/>
        <c:axId val="1195881120"/>
      </c:barChart>
      <c:catAx>
        <c:axId val="11958865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95881120"/>
        <c:crosses val="autoZero"/>
        <c:auto val="1"/>
        <c:lblAlgn val="ctr"/>
        <c:lblOffset val="100"/>
        <c:noMultiLvlLbl val="0"/>
      </c:catAx>
      <c:valAx>
        <c:axId val="11958811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GB" sz="1000" b="1" i="0" baseline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amount </a:t>
                </a:r>
                <a:r>
                  <a:rPr lang="en-US" sz="1000" b="1" i="0" baseline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µg/3*10</a:t>
                </a:r>
                <a:r>
                  <a:rPr lang="en-US" sz="1000" b="1" i="0" baseline="3000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 </a:t>
                </a:r>
                <a:r>
                  <a:rPr lang="en-US" sz="1000" b="1" i="0" baseline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Cells) </a:t>
                </a:r>
                <a:endParaRPr lang="en-GB" sz="1000" b="1"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958865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42652377143187581"/>
          <c:y val="2.793296089385474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1118727050183598"/>
          <c:y val="0.19243038754233932"/>
          <c:w val="0.83495716034271728"/>
          <c:h val="0.6851115118990014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RT PRE CALC.xlsx]Sheet2'!$Q$1</c:f>
              <c:strCache>
                <c:ptCount val="1"/>
                <c:pt idx="0">
                  <c:v>CBR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206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FCEE-4A3B-9E53-32FA22ACFE66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FCEE-4A3B-9E53-32FA22ACFE66}"/>
              </c:ext>
            </c:extLst>
          </c:dPt>
          <c:errBars>
            <c:errBarType val="both"/>
            <c:errValType val="cust"/>
            <c:noEndCap val="0"/>
            <c:plus>
              <c:numRef>
                <c:f>'[RT PRE CALC.xlsx]Sheet2'!$R$2:$R$3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42894861662625289</c:v>
                  </c:pt>
                </c:numCache>
              </c:numRef>
            </c:plus>
            <c:minus>
              <c:numRef>
                <c:f>'[RT PRE CALC.xlsx]Sheet2'!$R$2:$R$3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42894861662625289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RT PRE CALC.xlsx]Sheet2'!$B$2:$B$3</c:f>
              <c:strCache>
                <c:ptCount val="2"/>
                <c:pt idx="0">
                  <c:v>Control</c:v>
                </c:pt>
                <c:pt idx="1">
                  <c:v>Treated</c:v>
                </c:pt>
              </c:strCache>
            </c:strRef>
          </c:cat>
          <c:val>
            <c:numRef>
              <c:f>'[RT PRE CALC.xlsx]Sheet2'!$Q$2:$Q$3</c:f>
              <c:numCache>
                <c:formatCode>General</c:formatCode>
                <c:ptCount val="2"/>
                <c:pt idx="0">
                  <c:v>1</c:v>
                </c:pt>
                <c:pt idx="1">
                  <c:v>3.174349117275880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FCEE-4A3B-9E53-32FA22ACFE6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60535216"/>
        <c:axId val="1160533040"/>
      </c:barChart>
      <c:catAx>
        <c:axId val="11605352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60533040"/>
        <c:crosses val="autoZero"/>
        <c:auto val="1"/>
        <c:lblAlgn val="ctr"/>
        <c:lblOffset val="100"/>
        <c:noMultiLvlLbl val="0"/>
      </c:catAx>
      <c:valAx>
        <c:axId val="116053304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60535216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42910102529318667"/>
          <c:y val="2.777777777777777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3736569445673225"/>
          <c:y val="0.18777777777777777"/>
          <c:w val="0.80770296971305555"/>
          <c:h val="0.6815831146106736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RT PRE CALC.xlsx]Sheet2'!$S$1</c:f>
              <c:strCache>
                <c:ptCount val="1"/>
                <c:pt idx="0">
                  <c:v>Chloroplast TIDI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206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724F-4A6E-A5E7-A25B1F1B3483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724F-4A6E-A5E7-A25B1F1B3483}"/>
              </c:ext>
            </c:extLst>
          </c:dPt>
          <c:errBars>
            <c:errBarType val="both"/>
            <c:errValType val="cust"/>
            <c:noEndCap val="0"/>
            <c:plus>
              <c:numRef>
                <c:f>'[RT PRE CALC.xlsx]Sheet2'!$T$2:$T$3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58281701052483681</c:v>
                  </c:pt>
                </c:numCache>
              </c:numRef>
            </c:plus>
            <c:minus>
              <c:numRef>
                <c:f>'[RT PRE CALC.xlsx]Sheet2'!$T$2:$T$3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58281701052483681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RT PRE CALC.xlsx]Sheet2'!$B$2:$B$3</c:f>
              <c:strCache>
                <c:ptCount val="2"/>
                <c:pt idx="0">
                  <c:v>Control</c:v>
                </c:pt>
                <c:pt idx="1">
                  <c:v>Treated</c:v>
                </c:pt>
              </c:strCache>
            </c:strRef>
          </c:cat>
          <c:val>
            <c:numRef>
              <c:f>'[RT PRE CALC.xlsx]Sheet2'!$S$2:$S$3</c:f>
              <c:numCache>
                <c:formatCode>General</c:formatCode>
                <c:ptCount val="2"/>
                <c:pt idx="0">
                  <c:v>1</c:v>
                </c:pt>
                <c:pt idx="1">
                  <c:v>5.183618908037819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724F-4A6E-A5E7-A25B1F1B348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60530320"/>
        <c:axId val="1160542832"/>
      </c:barChart>
      <c:catAx>
        <c:axId val="11605303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60542832"/>
        <c:crosses val="autoZero"/>
        <c:auto val="1"/>
        <c:lblAlgn val="ctr"/>
        <c:lblOffset val="100"/>
        <c:noMultiLvlLbl val="0"/>
      </c:catAx>
      <c:valAx>
        <c:axId val="116054283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60530320"/>
        <c:crosses val="autoZero"/>
        <c:crossBetween val="between"/>
        <c:majorUnit val="1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40861689106487148"/>
          <c:y val="6.970512326322993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2737817885123909"/>
          <c:y val="0.17235772357723578"/>
          <c:w val="0.80770296971305555"/>
          <c:h val="0.6985818236135117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RT PRE CALC.xlsx]Sheet2'!$U$1</c:f>
              <c:strCache>
                <c:ptCount val="1"/>
                <c:pt idx="0">
                  <c:v>s-FLP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206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37A1-4EB6-B495-DBD2096E3C44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37A1-4EB6-B495-DBD2096E3C44}"/>
              </c:ext>
            </c:extLst>
          </c:dPt>
          <c:errBars>
            <c:errBarType val="both"/>
            <c:errValType val="cust"/>
            <c:noEndCap val="0"/>
            <c:plus>
              <c:numRef>
                <c:f>'[RT PRE CALC.xlsx]Sheet2'!$V$2:$V$3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6329336247239078</c:v>
                  </c:pt>
                </c:numCache>
              </c:numRef>
            </c:plus>
            <c:minus>
              <c:numRef>
                <c:f>'[RT PRE CALC.xlsx]Sheet2'!$V$2:$V$3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6329336247239078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RT PRE CALC.xlsx]Sheet2'!$B$2:$B$3</c:f>
              <c:strCache>
                <c:ptCount val="2"/>
                <c:pt idx="0">
                  <c:v>Control</c:v>
                </c:pt>
                <c:pt idx="1">
                  <c:v>Treated</c:v>
                </c:pt>
              </c:strCache>
            </c:strRef>
          </c:cat>
          <c:val>
            <c:numRef>
              <c:f>'[RT PRE CALC.xlsx]Sheet2'!$U$2:$U$3</c:f>
              <c:numCache>
                <c:formatCode>General</c:formatCode>
                <c:ptCount val="2"/>
                <c:pt idx="0">
                  <c:v>1</c:v>
                </c:pt>
                <c:pt idx="1">
                  <c:v>5.746249586624304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37A1-4EB6-B495-DBD2096E3C4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60544464"/>
        <c:axId val="1160530864"/>
      </c:barChart>
      <c:catAx>
        <c:axId val="11605444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60530864"/>
        <c:crosses val="autoZero"/>
        <c:auto val="1"/>
        <c:lblAlgn val="ctr"/>
        <c:lblOffset val="100"/>
        <c:noMultiLvlLbl val="0"/>
      </c:catAx>
      <c:valAx>
        <c:axId val="116053086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60544464"/>
        <c:crosses val="autoZero"/>
        <c:crossBetween val="between"/>
        <c:majorUnit val="1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24057879825180764"/>
          <c:y val="3.184713375796178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2840813899079723"/>
          <c:y val="0.14369973190348523"/>
          <c:w val="0.82024257300732972"/>
          <c:h val="0.6926807540478351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RT PRE CALC.xlsx]Sheet2'!$C$1</c:f>
              <c:strCache>
                <c:ptCount val="1"/>
                <c:pt idx="0">
                  <c:v>Heme oxygenas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206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4EBE-4408-B050-5128AC25ACDD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4EBE-4408-B050-5128AC25ACDD}"/>
              </c:ext>
            </c:extLst>
          </c:dPt>
          <c:errBars>
            <c:errBarType val="both"/>
            <c:errValType val="cust"/>
            <c:noEndCap val="0"/>
            <c:plus>
              <c:numRef>
                <c:f>'[RT PRE CALC.xlsx]Sheet2'!$D$2:$D$3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79302452248500122</c:v>
                  </c:pt>
                </c:numCache>
              </c:numRef>
            </c:plus>
            <c:minus>
              <c:numRef>
                <c:f>'[RT PRE CALC.xlsx]Sheet2'!$D$2:$D$3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79302452248500122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RT PRE CALC.xlsx]Sheet2'!$B$2:$B$3</c:f>
              <c:strCache>
                <c:ptCount val="2"/>
                <c:pt idx="0">
                  <c:v>Control</c:v>
                </c:pt>
                <c:pt idx="1">
                  <c:v>Treated</c:v>
                </c:pt>
              </c:strCache>
            </c:strRef>
          </c:cat>
          <c:val>
            <c:numRef>
              <c:f>'[RT PRE CALC.xlsx]Sheet2'!$C$2:$C$3</c:f>
              <c:numCache>
                <c:formatCode>General</c:formatCode>
                <c:ptCount val="2"/>
                <c:pt idx="0">
                  <c:v>1</c:v>
                </c:pt>
                <c:pt idx="1">
                  <c:v>3.505314417620116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4EBE-4408-B050-5128AC25AC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60534128"/>
        <c:axId val="1160543376"/>
      </c:barChart>
      <c:catAx>
        <c:axId val="11605341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60543376"/>
        <c:crosses val="autoZero"/>
        <c:auto val="1"/>
        <c:lblAlgn val="ctr"/>
        <c:lblOffset val="100"/>
        <c:noMultiLvlLbl val="0"/>
      </c:catAx>
      <c:valAx>
        <c:axId val="116054337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60534128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dirty="0"/>
              <a:t>TRX like 2-1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9.86805440935173E-2"/>
          <c:y val="0.19259259259259257"/>
          <c:w val="0.82240453605444819"/>
          <c:h val="0.6305231599599585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RT PRE CALC.xlsx]Sheet2'!$I$1</c:f>
              <c:strCache>
                <c:ptCount val="1"/>
                <c:pt idx="0">
                  <c:v>TRX LIKE 2-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206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D943-4B94-9DED-5B32B462FC57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D943-4B94-9DED-5B32B462FC57}"/>
              </c:ext>
            </c:extLst>
          </c:dPt>
          <c:errBars>
            <c:errBarType val="both"/>
            <c:errValType val="cust"/>
            <c:noEndCap val="0"/>
            <c:plus>
              <c:numRef>
                <c:f>'[RT PRE CALC.xlsx]Sheet2'!$J$2:$J$3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1.5972593669157225</c:v>
                  </c:pt>
                </c:numCache>
              </c:numRef>
            </c:plus>
            <c:minus>
              <c:numRef>
                <c:f>'[RT PRE CALC.xlsx]Sheet2'!$J$2:$J$3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1.5972593669157225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RT PRE CALC.xlsx]Sheet2'!$B$2:$B$3</c:f>
              <c:strCache>
                <c:ptCount val="2"/>
                <c:pt idx="0">
                  <c:v>Control</c:v>
                </c:pt>
                <c:pt idx="1">
                  <c:v>Treated</c:v>
                </c:pt>
              </c:strCache>
            </c:strRef>
          </c:cat>
          <c:val>
            <c:numRef>
              <c:f>'[RT PRE CALC.xlsx]Sheet2'!$I$2:$I$3</c:f>
              <c:numCache>
                <c:formatCode>General</c:formatCode>
                <c:ptCount val="2"/>
                <c:pt idx="0">
                  <c:v>1</c:v>
                </c:pt>
                <c:pt idx="1">
                  <c:v>12.04314212431086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D943-4B94-9DED-5B32B462FC5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60543920"/>
        <c:axId val="1160535760"/>
      </c:barChart>
      <c:catAx>
        <c:axId val="1160543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60535760"/>
        <c:crosses val="autoZero"/>
        <c:auto val="1"/>
        <c:lblAlgn val="ctr"/>
        <c:lblOffset val="100"/>
        <c:noMultiLvlLbl val="0"/>
      </c:catAx>
      <c:valAx>
        <c:axId val="116053576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60543920"/>
        <c:crosses val="autoZero"/>
        <c:crossBetween val="between"/>
        <c:majorUnit val="4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RT PRE CALC.xlsx]Sheet2'!$E$1</c:f>
              <c:strCache>
                <c:ptCount val="1"/>
                <c:pt idx="0">
                  <c:v>PsbW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206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22B0-4334-8371-95DDB7781B7A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22B0-4334-8371-95DDB7781B7A}"/>
              </c:ext>
            </c:extLst>
          </c:dPt>
          <c:errBars>
            <c:errBarType val="both"/>
            <c:errValType val="cust"/>
            <c:noEndCap val="0"/>
            <c:plus>
              <c:numRef>
                <c:f>'[RT PRE CALC.xlsx]Sheet2'!$F$2:$F$3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73904557630987666</c:v>
                  </c:pt>
                </c:numCache>
              </c:numRef>
            </c:plus>
            <c:minus>
              <c:numRef>
                <c:f>'[RT PRE CALC.xlsx]Sheet2'!$F$2:$F$3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73904557630987666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RT PRE CALC.xlsx]Sheet2'!$B$2:$B$3</c:f>
              <c:strCache>
                <c:ptCount val="2"/>
                <c:pt idx="0">
                  <c:v>Control</c:v>
                </c:pt>
                <c:pt idx="1">
                  <c:v>Treated</c:v>
                </c:pt>
              </c:strCache>
            </c:strRef>
          </c:cat>
          <c:val>
            <c:numRef>
              <c:f>'[RT PRE CALC.xlsx]Sheet2'!$E$2:$E$3</c:f>
              <c:numCache>
                <c:formatCode>General</c:formatCode>
                <c:ptCount val="2"/>
                <c:pt idx="0">
                  <c:v>1</c:v>
                </c:pt>
                <c:pt idx="1">
                  <c:v>6.999014562628402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22B0-4334-8371-95DDB7781B7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60536304"/>
        <c:axId val="1160537936"/>
      </c:barChart>
      <c:catAx>
        <c:axId val="11605363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60537936"/>
        <c:crosses val="autoZero"/>
        <c:auto val="1"/>
        <c:lblAlgn val="ctr"/>
        <c:lblOffset val="100"/>
        <c:noMultiLvlLbl val="0"/>
      </c:catAx>
      <c:valAx>
        <c:axId val="116053793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60536304"/>
        <c:crosses val="autoZero"/>
        <c:crossBetween val="between"/>
        <c:majorUnit val="1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32368503368579454"/>
          <c:y val="0.1126760563380281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2840813899079723"/>
          <c:y val="0.18478873239436616"/>
          <c:w val="0.82024257300732972"/>
          <c:h val="0.6976779042029933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RT PRE CALC.xlsx]Sheet2'!$M$1</c:f>
              <c:strCache>
                <c:ptCount val="1"/>
                <c:pt idx="0">
                  <c:v>ATP synthase gamma 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206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D7F6-4072-8528-9E5CE48B66ED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D7F6-4072-8528-9E5CE48B66ED}"/>
              </c:ext>
            </c:extLst>
          </c:dPt>
          <c:errBars>
            <c:errBarType val="both"/>
            <c:errValType val="cust"/>
            <c:noEndCap val="0"/>
            <c:plus>
              <c:numRef>
                <c:f>'[RT PRE CALC.xlsx]Sheet2'!$N$2:$N$3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34034409707650348</c:v>
                  </c:pt>
                </c:numCache>
              </c:numRef>
            </c:plus>
            <c:minus>
              <c:numRef>
                <c:f>'[RT PRE CALC.xlsx]Sheet2'!$N$2:$N$3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34034409707650348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RT PRE CALC.xlsx]Sheet2'!$B$2:$B$3</c:f>
              <c:strCache>
                <c:ptCount val="2"/>
                <c:pt idx="0">
                  <c:v>Control</c:v>
                </c:pt>
                <c:pt idx="1">
                  <c:v>Treated</c:v>
                </c:pt>
              </c:strCache>
            </c:strRef>
          </c:cat>
          <c:val>
            <c:numRef>
              <c:f>'[RT PRE CALC.xlsx]Sheet2'!$M$2:$M$3</c:f>
              <c:numCache>
                <c:formatCode>General</c:formatCode>
                <c:ptCount val="2"/>
                <c:pt idx="0">
                  <c:v>1</c:v>
                </c:pt>
                <c:pt idx="1">
                  <c:v>7.182612070374982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D7F6-4072-8528-9E5CE48B66E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60536848"/>
        <c:axId val="1160538480"/>
      </c:barChart>
      <c:catAx>
        <c:axId val="11605368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60538480"/>
        <c:crosses val="autoZero"/>
        <c:auto val="1"/>
        <c:lblAlgn val="ctr"/>
        <c:lblOffset val="100"/>
        <c:noMultiLvlLbl val="0"/>
      </c:catAx>
      <c:valAx>
        <c:axId val="116053848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60536848"/>
        <c:crosses val="autoZero"/>
        <c:crossBetween val="between"/>
        <c:majorUnit val="1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2769702285336987"/>
          <c:y val="0.19314285714285712"/>
          <c:w val="0.80722162545701814"/>
          <c:h val="0.6724854893138357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RT PRE CALC.xlsx]Sheet2'!$K$1</c:f>
              <c:strCache>
                <c:ptCount val="1"/>
                <c:pt idx="0">
                  <c:v>Glutathione peroxidas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206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564F-4ABC-9E47-48276DE253F8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564F-4ABC-9E47-48276DE253F8}"/>
              </c:ext>
            </c:extLst>
          </c:dPt>
          <c:errBars>
            <c:errBarType val="both"/>
            <c:errValType val="cust"/>
            <c:noEndCap val="0"/>
            <c:plus>
              <c:numRef>
                <c:f>'[RT PRE CALC.xlsx]Sheet2'!$L$2:$L$3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39970926084233621</c:v>
                  </c:pt>
                </c:numCache>
              </c:numRef>
            </c:plus>
            <c:minus>
              <c:numRef>
                <c:f>'[RT PRE CALC.xlsx]Sheet2'!$L$2:$L$3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39970926084233621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RT PRE CALC.xlsx]Sheet2'!$B$2:$B$3</c:f>
              <c:strCache>
                <c:ptCount val="2"/>
                <c:pt idx="0">
                  <c:v>Control</c:v>
                </c:pt>
                <c:pt idx="1">
                  <c:v>Treated</c:v>
                </c:pt>
              </c:strCache>
            </c:strRef>
          </c:cat>
          <c:val>
            <c:numRef>
              <c:f>'[RT PRE CALC.xlsx]Sheet2'!$K$2:$K$3</c:f>
              <c:numCache>
                <c:formatCode>General</c:formatCode>
                <c:ptCount val="2"/>
                <c:pt idx="0">
                  <c:v>1</c:v>
                </c:pt>
                <c:pt idx="1">
                  <c:v>2.180733502729259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564F-4ABC-9E47-48276DE253F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60539024"/>
        <c:axId val="1160545008"/>
      </c:barChart>
      <c:catAx>
        <c:axId val="11605390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60545008"/>
        <c:crosses val="autoZero"/>
        <c:auto val="1"/>
        <c:lblAlgn val="ctr"/>
        <c:lblOffset val="100"/>
        <c:noMultiLvlLbl val="0"/>
      </c:catAx>
      <c:valAx>
        <c:axId val="116054500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605390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A356F4F-0E66-2B59-B719-DB105DBAE17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3EA59ACD-3633-8171-2487-475E2132BB4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D1C4A35A-9A0B-49F0-E19F-2DD0145B76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EB20B-24EE-4DE1-9493-C1097A2E14D2}" type="datetimeFigureOut">
              <a:rPr lang="en-GB" smtClean="0"/>
              <a:t>20/03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19C5B6AE-BB77-3E33-AD25-AC8BEB7F91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1E32DE0-DB1D-94DF-B32E-D63AC0251C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F212A-A7B8-4AF9-82C6-29D1C94FBF9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830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DF48A67-E66F-635A-65DF-693253CAC4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D9CB1FC9-F5BB-C9AF-A24F-46E1719F231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E223B4B0-4AC5-3305-CC36-D35F51AD0C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EB20B-24EE-4DE1-9493-C1097A2E14D2}" type="datetimeFigureOut">
              <a:rPr lang="en-GB" smtClean="0"/>
              <a:t>20/03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D37E1A9E-CB53-8E60-B186-3ADF022D4A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403F28B3-DC2A-8A6A-45EF-C11B8D138D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F212A-A7B8-4AF9-82C6-29D1C94FBF9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38132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239506FB-B34E-BF9C-175D-B2CFC799492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896B85FB-1BB5-5C58-3904-2931F1146B1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0ABFE0D4-93C4-1882-3A61-874FE097ED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EB20B-24EE-4DE1-9493-C1097A2E14D2}" type="datetimeFigureOut">
              <a:rPr lang="en-GB" smtClean="0"/>
              <a:t>20/03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45C40E7-DE2E-CFBE-B43A-91FC5DB39B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2D404009-70A7-870F-6366-DC663A12F8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F212A-A7B8-4AF9-82C6-29D1C94FBF9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78261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77F1A4B-5738-255D-26AF-99CC8A19A2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D2184A97-276D-3898-8691-8E08885F55E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697BEAE4-A310-9D1E-970E-526CBFAE5E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EB20B-24EE-4DE1-9493-C1097A2E14D2}" type="datetimeFigureOut">
              <a:rPr lang="en-GB" smtClean="0"/>
              <a:t>20/03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4E19BAE2-893C-4AEB-3E70-087E14D3D6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983AFEB3-CF08-BC32-9008-29C20E6653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F212A-A7B8-4AF9-82C6-29D1C94FBF9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23906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F8D44A1-046F-6F06-B131-BF4435A836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965AF912-DCE3-AA98-1053-C3EE5D801D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4F3E9E8D-7213-E78F-B764-E5E605FA8B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EB20B-24EE-4DE1-9493-C1097A2E14D2}" type="datetimeFigureOut">
              <a:rPr lang="en-GB" smtClean="0"/>
              <a:t>20/03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02940A9A-E921-D0B7-5013-7E5021936B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78A94AAB-15D4-5D7D-7F14-F1B16CA13A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F212A-A7B8-4AF9-82C6-29D1C94FBF9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3171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CA519FD-E914-C4C7-5AD4-796D5C47E1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41BECB91-9579-D1A2-3163-0F3D6D5CD33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F7C2C9E2-0FB3-65A1-ED96-CFEB4EEF0FF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AF36392B-4014-48B3-6011-49764EBD1E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EB20B-24EE-4DE1-9493-C1097A2E14D2}" type="datetimeFigureOut">
              <a:rPr lang="en-GB" smtClean="0"/>
              <a:t>20/03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B24734ED-0043-7ADC-A2C6-C16C59ADE6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9D106F3B-36F9-D5A9-C89B-7EB4311C28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F212A-A7B8-4AF9-82C6-29D1C94FBF9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97535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BC6F164-6010-6245-E648-2479345630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B6F272EB-1CE7-7F07-A565-2BBED71778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54B85673-F4C2-9320-A201-5EBB481245A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F024E8C3-10C9-81C9-9E18-F88E4461800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DEBD20E2-93E3-3DC9-3C2C-5B975E94C1B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4DD109C5-776D-FA41-3924-F5A7FFF293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EB20B-24EE-4DE1-9493-C1097A2E14D2}" type="datetimeFigureOut">
              <a:rPr lang="en-GB" smtClean="0"/>
              <a:t>20/03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E64814FE-3987-C352-84CF-B8308496BF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B5EDB72E-F740-5229-758A-2449B01891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F212A-A7B8-4AF9-82C6-29D1C94FBF9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34078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49694C9-E3C6-DC3B-79E2-2226EB28E9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4549101A-F092-3722-1014-1DB5CA3308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EB20B-24EE-4DE1-9493-C1097A2E14D2}" type="datetimeFigureOut">
              <a:rPr lang="en-GB" smtClean="0"/>
              <a:t>20/03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BBBA2EED-C38B-6751-FDCC-2ECB700BDA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ECFC1851-D91A-E16D-8488-624B8F0521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F212A-A7B8-4AF9-82C6-29D1C94FBF9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68494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1AC206FE-469C-29B6-3300-50CA82B417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EB20B-24EE-4DE1-9493-C1097A2E14D2}" type="datetimeFigureOut">
              <a:rPr lang="en-GB" smtClean="0"/>
              <a:t>20/03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04483C95-697D-4161-8D34-BCC7C2D550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4D0ED9E2-348C-13DB-178C-76C846479F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F212A-A7B8-4AF9-82C6-29D1C94FBF9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62120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07B3D0F-AC61-BAC3-3C4D-60FC45EC51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ECB5CC61-347E-776A-B79A-23E028DDFA5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C004AA57-49F4-38BA-9C43-5609FA24665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5C2627E8-E1C1-2B6A-9C73-5DE1D8665A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EB20B-24EE-4DE1-9493-C1097A2E14D2}" type="datetimeFigureOut">
              <a:rPr lang="en-GB" smtClean="0"/>
              <a:t>20/03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3273EC6C-7559-0DAE-C755-71317994CA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C5E90E3F-CE4F-9C14-FF10-85A153ADC7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F212A-A7B8-4AF9-82C6-29D1C94FBF9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82351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1891A8B-3A6F-A6EE-8B1A-478E83124E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46584432-DAFE-BD76-6973-708E2CDD370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1ECA8585-0584-A9F4-EB8F-F8F0427D1D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1DDD224D-CB5D-9863-88CD-736AEB2E6F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EB20B-24EE-4DE1-9493-C1097A2E14D2}" type="datetimeFigureOut">
              <a:rPr lang="en-GB" smtClean="0"/>
              <a:t>20/03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D30A6B30-4043-F426-9247-178697C94F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15AB5270-D77B-04AE-FC8E-1FF35BBA99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F212A-A7B8-4AF9-82C6-29D1C94FBF9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69845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AE25B990-C073-A825-C5A0-89829BBB43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1E4AD54B-8E52-697E-6C1E-041A296090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6D3CC3EB-CBC9-20F5-300F-3723E9C3FAB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5EB20B-24EE-4DE1-9493-C1097A2E14D2}" type="datetimeFigureOut">
              <a:rPr lang="en-GB" smtClean="0"/>
              <a:t>20/03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A1DD3D35-BB72-82CB-DACF-7BCBEACD15A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F215CE91-CC9C-2409-66F3-935E5B0F9AF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BF212A-A7B8-4AF9-82C6-29D1C94FBF9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83276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chart" Target="../charts/chart1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13.xml"/><Relationship Id="rId4" Type="http://schemas.openxmlformats.org/officeDocument/2006/relationships/chart" Target="../charts/chart1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5.xml"/><Relationship Id="rId2" Type="http://schemas.openxmlformats.org/officeDocument/2006/relationships/chart" Target="../charts/chart14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17.xml"/><Relationship Id="rId4" Type="http://schemas.openxmlformats.org/officeDocument/2006/relationships/chart" Target="../charts/chart16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mp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68AC0720-836C-C03F-6848-7EA8DEA7B875}"/>
              </a:ext>
            </a:extLst>
          </p:cNvPr>
          <p:cNvSpPr txBox="1"/>
          <p:nvPr/>
        </p:nvSpPr>
        <p:spPr>
          <a:xfrm>
            <a:off x="3852809" y="2619910"/>
            <a:ext cx="703779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2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S AND TABLES</a:t>
            </a:r>
            <a:endParaRPr lang="en-GB" sz="2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295532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xmlns="" id="{7E3AEFAA-24DD-FD6F-8F93-BB9B7C6E704A}"/>
              </a:ext>
            </a:extLst>
          </p:cNvPr>
          <p:cNvGraphicFramePr>
            <a:graphicFrameLocks noGrp="1"/>
          </p:cNvGraphicFramePr>
          <p:nvPr/>
        </p:nvGraphicFramePr>
        <p:xfrm>
          <a:off x="1461436" y="712269"/>
          <a:ext cx="9269128" cy="4947388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2514980">
                  <a:extLst>
                    <a:ext uri="{9D8B030D-6E8A-4147-A177-3AD203B41FA5}">
                      <a16:colId xmlns:a16="http://schemas.microsoft.com/office/drawing/2014/main" xmlns="" val="638796081"/>
                    </a:ext>
                  </a:extLst>
                </a:gridCol>
                <a:gridCol w="1763079">
                  <a:extLst>
                    <a:ext uri="{9D8B030D-6E8A-4147-A177-3AD203B41FA5}">
                      <a16:colId xmlns:a16="http://schemas.microsoft.com/office/drawing/2014/main" xmlns="" val="754100166"/>
                    </a:ext>
                  </a:extLst>
                </a:gridCol>
                <a:gridCol w="2203849">
                  <a:extLst>
                    <a:ext uri="{9D8B030D-6E8A-4147-A177-3AD203B41FA5}">
                      <a16:colId xmlns:a16="http://schemas.microsoft.com/office/drawing/2014/main" xmlns="" val="3782965667"/>
                    </a:ext>
                  </a:extLst>
                </a:gridCol>
                <a:gridCol w="1866789">
                  <a:extLst>
                    <a:ext uri="{9D8B030D-6E8A-4147-A177-3AD203B41FA5}">
                      <a16:colId xmlns:a16="http://schemas.microsoft.com/office/drawing/2014/main" xmlns="" val="1863622332"/>
                    </a:ext>
                  </a:extLst>
                </a:gridCol>
                <a:gridCol w="920431">
                  <a:extLst>
                    <a:ext uri="{9D8B030D-6E8A-4147-A177-3AD203B41FA5}">
                      <a16:colId xmlns:a16="http://schemas.microsoft.com/office/drawing/2014/main" xmlns="" val="111546610"/>
                    </a:ext>
                  </a:extLst>
                </a:gridCol>
              </a:tblGrid>
              <a:tr h="774198"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 ID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s</a:t>
                      </a:r>
                      <a:endParaRPr lang="en-GB" sz="16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PKM values of control</a:t>
                      </a:r>
                      <a:endParaRPr lang="en-GB" sz="16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PKM values of treated</a:t>
                      </a:r>
                      <a:endParaRPr lang="en-GB" sz="16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g2fold change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>
                    <a:solidFill>
                      <a:schemeClr val="bg2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21331717"/>
                  </a:ext>
                </a:extLst>
              </a:tr>
              <a:tr h="4173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10949_c0_g1_i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YB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53943061</a:t>
                      </a:r>
                      <a:endParaRPr lang="en-GB" sz="1200" b="0" i="0" u="none" strike="noStrike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.6950145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4106594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xmlns="" val="3564174794"/>
                  </a:ext>
                </a:extLst>
              </a:tr>
              <a:tr h="4173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5966_c0_g1_i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P97B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.82023955</a:t>
                      </a:r>
                      <a:endParaRPr lang="en-GB" sz="1200" b="0" i="0" u="none" strike="noStrike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.7685645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9189467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xmlns="" val="3364884226"/>
                  </a:ext>
                </a:extLst>
              </a:tr>
              <a:tr h="4173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3194_c0_g1_i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P97A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.26444203</a:t>
                      </a:r>
                      <a:endParaRPr lang="en-GB" sz="1200" b="0" i="0" u="none" strike="noStrike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.2171305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5931394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xmlns="" val="677400000"/>
                  </a:ext>
                </a:extLst>
              </a:tr>
              <a:tr h="4173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4283_c0_g1_i2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P97C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165376754</a:t>
                      </a:r>
                      <a:endParaRPr lang="en-GB" sz="1200" b="0" i="0" u="none" strike="noStrike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1905979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797486394</a:t>
                      </a:r>
                      <a:endParaRPr lang="en-GB" sz="1200" b="0" i="0" u="none" strike="noStrike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xmlns="" val="4105395483"/>
                  </a:ext>
                </a:extLst>
              </a:tr>
              <a:tr h="4173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6289_c0_g1_i2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CYE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1.1706262</a:t>
                      </a:r>
                      <a:endParaRPr lang="en-GB" sz="1200" b="0" i="0" u="none" strike="noStrike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8.82940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8687867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xmlns="" val="1377251085"/>
                  </a:ext>
                </a:extLst>
              </a:tr>
              <a:tr h="4173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1403_c0_g1_i1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CY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.11005373</a:t>
                      </a:r>
                      <a:endParaRPr lang="en-GB" sz="1200" b="0" i="0" u="none" strike="noStrike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.1227841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94225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xmlns="" val="3032352584"/>
                  </a:ext>
                </a:extLst>
              </a:tr>
              <a:tr h="4173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4573_c0_g3_i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DS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21305516</a:t>
                      </a:r>
                      <a:endParaRPr lang="en-GB" sz="1200" b="0" i="0" u="none" strike="noStrike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1.2646099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8317900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xmlns="" val="2277682947"/>
                  </a:ext>
                </a:extLst>
              </a:tr>
              <a:tr h="4173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2651_c0_g2_i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Y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.38670916</a:t>
                      </a:r>
                      <a:endParaRPr lang="en-GB" sz="1200" b="0" i="0" u="none" strike="noStrike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3.6334268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</a:t>
                      </a:r>
                      <a:endParaRPr lang="en-GB" sz="1200" b="0" i="0" u="none" strike="noStrike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xmlns="" val="2263095753"/>
                  </a:ext>
                </a:extLst>
              </a:tr>
              <a:tr h="4173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114_c0_g5_i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DS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4.35957836</a:t>
                      </a:r>
                      <a:endParaRPr lang="en-GB" sz="1200" b="0" i="0" u="none" strike="noStrike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.40791409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</a:t>
                      </a:r>
                      <a:endParaRPr lang="en-GB" sz="1200" b="0" i="0" u="none" strike="noStrike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xmlns="" val="4091691859"/>
                  </a:ext>
                </a:extLst>
              </a:tr>
              <a:tr h="4173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4235_c1_g2_i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DE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7.8947074</a:t>
                      </a:r>
                      <a:endParaRPr lang="en-GB" sz="1200" b="0" i="0" u="none" strike="noStrike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1.2621695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57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xmlns="" val="3946412033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EA84CDB9-BA32-0101-4493-775B259BDD28}"/>
              </a:ext>
            </a:extLst>
          </p:cNvPr>
          <p:cNvSpPr txBox="1"/>
          <p:nvPr/>
        </p:nvSpPr>
        <p:spPr>
          <a:xfrm>
            <a:off x="409308" y="107654"/>
            <a:ext cx="2983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GB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267691" y="0"/>
            <a:ext cx="15794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/>
              <a:t>S Table 2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5593234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>
        <mc:Choice xmlns:pslz="http://schemas.microsoft.com/office/powerpoint/2016/slidezoom" xmlns="" Requires="pslz">
          <p:graphicFrame>
            <p:nvGraphicFramePr>
              <p:cNvPr id="3" name="Slide Zoom 2">
                <a:extLst>
                  <a:ext uri="{FF2B5EF4-FFF2-40B4-BE49-F238E27FC236}">
                    <a16:creationId xmlns:a16="http://schemas.microsoft.com/office/drawing/2014/main" id="{3ECEC764-A4A0-34C4-AAA8-5DED8B93CCB2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2132573" y="2089226"/>
              <a:ext cx="3048000" cy="1714500"/>
            </p:xfrm>
            <a:graphic>
              <a:graphicData uri="http://schemas.microsoft.com/office/powerpoint/2016/slidezoom">
                <pslz:sldZm>
                  <pslz:sldZmObj sldId="282" cId="277116218">
                    <pslz:zmPr id="{FF9411C2-66B2-4780-8293-208765DA513E}" returnToParent="0" transitionDur="1000">
                      <p166:blipFill xmlns:p166="http://schemas.microsoft.com/office/powerpoint/2016/6/main">
                        <a:blip r:embed="rId2"/>
                        <a:stretch>
                          <a:fillRect/>
                        </a:stretch>
                      </p166:blipFill>
                      <p166:spPr xmlns:p166="http://schemas.microsoft.com/office/powerpoint/2016/6/main">
                        <a:xfrm>
                          <a:off x="0" y="0"/>
                          <a:ext cx="3048000" cy="1714500"/>
                        </a:xfrm>
                        <a:prstGeom prst="rect">
                          <a:avLst/>
                        </a:prstGeom>
                        <a:ln w="3175">
                          <a:solidFill>
                            <a:prstClr val="ltGray"/>
                          </a:solidFill>
                        </a:ln>
                      </p166:spPr>
                    </pslz:zmPr>
                  </pslz:sldZmObj>
                </pslz:sldZm>
              </a:graphicData>
            </a:graphic>
          </p:graphicFrame>
        </mc:Choice>
        <mc:Fallback>
          <p:pic>
            <p:nvPicPr>
              <p:cNvPr id="3" name="Slide Zoom 2">
                <a:extLst>
                  <a:ext uri="{FF2B5EF4-FFF2-40B4-BE49-F238E27FC236}">
                    <a16:creationId xmlns:a16="http://schemas.microsoft.com/office/drawing/2014/main" xmlns="" xmlns:pslz="http://schemas.microsoft.com/office/powerpoint/2016/slidezoom" id="{3ECEC764-A4A0-34C4-AAA8-5DED8B93CCB2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132573" y="2089226"/>
                <a:ext cx="3048000" cy="1714500"/>
              </a:xfrm>
              <a:prstGeom prst="rect">
                <a:avLst/>
              </a:prstGeom>
              <a:ln w="3175">
                <a:solidFill>
                  <a:prstClr val="ltGray"/>
                </a:solidFill>
              </a:ln>
            </p:spPr>
          </p:pic>
        </mc:Fallback>
      </mc:AlternateContent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628D387C-5BE3-FBF8-4227-0C447A847C2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B743B579-99AC-7751-D1A2-C8B551C063EF}"/>
              </a:ext>
            </a:extLst>
          </p:cNvPr>
          <p:cNvSpPr txBox="1"/>
          <p:nvPr/>
        </p:nvSpPr>
        <p:spPr>
          <a:xfrm>
            <a:off x="250497" y="439300"/>
            <a:ext cx="2983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GB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E20644E2-F46F-F6A7-0E81-4D11F10CB9EC}"/>
              </a:ext>
            </a:extLst>
          </p:cNvPr>
          <p:cNvSpPr txBox="1"/>
          <p:nvPr/>
        </p:nvSpPr>
        <p:spPr>
          <a:xfrm>
            <a:off x="5269950" y="439300"/>
            <a:ext cx="8260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GB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613064" y="124691"/>
            <a:ext cx="39069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/>
              <a:t>S Figure 1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2771162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xmlns="" id="{5B513FDE-E3FF-85C9-F21F-5B338A501EEA}"/>
              </a:ext>
            </a:extLst>
          </p:cNvPr>
          <p:cNvGrpSpPr/>
          <p:nvPr/>
        </p:nvGrpSpPr>
        <p:grpSpPr>
          <a:xfrm>
            <a:off x="409308" y="0"/>
            <a:ext cx="11532367" cy="6788461"/>
            <a:chOff x="409308" y="0"/>
            <a:chExt cx="11532367" cy="6788461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xmlns="" id="{F7EF5A52-6E9A-0B0D-6741-5C8F5E4AF45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208" r="4812" b="2905"/>
            <a:stretch/>
          </p:blipFill>
          <p:spPr>
            <a:xfrm>
              <a:off x="707691" y="1978060"/>
              <a:ext cx="4065141" cy="3573098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xmlns="" id="{C07C4571-5D70-61D7-604B-E16C5592B87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82"/>
            <a:stretch/>
          </p:blipFill>
          <p:spPr>
            <a:xfrm>
              <a:off x="5580114" y="0"/>
              <a:ext cx="6361561" cy="6788461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xmlns="" id="{B4B73289-357E-F234-BFEE-A64A2DA4916A}"/>
                </a:ext>
              </a:extLst>
            </p:cNvPr>
            <p:cNvSpPr txBox="1"/>
            <p:nvPr/>
          </p:nvSpPr>
          <p:spPr>
            <a:xfrm>
              <a:off x="409308" y="107654"/>
              <a:ext cx="29838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xmlns="" id="{66CBA371-C1C2-3B95-57CB-D6EA57764711}"/>
                </a:ext>
              </a:extLst>
            </p:cNvPr>
            <p:cNvSpPr txBox="1"/>
            <p:nvPr/>
          </p:nvSpPr>
          <p:spPr>
            <a:xfrm>
              <a:off x="5775843" y="107654"/>
              <a:ext cx="29838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7" name="TextBox 6"/>
          <p:cNvSpPr txBox="1"/>
          <p:nvPr/>
        </p:nvSpPr>
        <p:spPr>
          <a:xfrm>
            <a:off x="2223655" y="135081"/>
            <a:ext cx="39069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/>
              <a:t>S Figure 2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11866957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/>
          <p:cNvGrpSpPr/>
          <p:nvPr/>
        </p:nvGrpSpPr>
        <p:grpSpPr>
          <a:xfrm>
            <a:off x="791663" y="74687"/>
            <a:ext cx="11400337" cy="6928785"/>
            <a:chOff x="318766" y="-70785"/>
            <a:chExt cx="11400337" cy="6928785"/>
          </a:xfrm>
        </p:grpSpPr>
        <p:graphicFrame>
          <p:nvGraphicFramePr>
            <p:cNvPr id="2" name="Chart 1">
              <a:extLst>
                <a:ext uri="{FF2B5EF4-FFF2-40B4-BE49-F238E27FC236}">
                  <a16:creationId xmlns:a16="http://schemas.microsoft.com/office/drawing/2014/main" xmlns="" id="{7652DAAF-C3DD-A012-589C-F08BF14E1C35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49501551"/>
                </p:ext>
              </p:extLst>
            </p:nvPr>
          </p:nvGraphicFramePr>
          <p:xfrm>
            <a:off x="344854" y="0"/>
            <a:ext cx="2720583" cy="236855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3" name="Chart 2">
              <a:extLst>
                <a:ext uri="{FF2B5EF4-FFF2-40B4-BE49-F238E27FC236}">
                  <a16:creationId xmlns:a16="http://schemas.microsoft.com/office/drawing/2014/main" xmlns="" id="{4DCADD49-F77D-698E-7123-3A213ED67C7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85510966"/>
                </p:ext>
              </p:extLst>
            </p:nvPr>
          </p:nvGraphicFramePr>
          <p:xfrm>
            <a:off x="9125128" y="-63434"/>
            <a:ext cx="2593975" cy="22733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4" name="Chart 3">
              <a:extLst>
                <a:ext uri="{FF2B5EF4-FFF2-40B4-BE49-F238E27FC236}">
                  <a16:creationId xmlns:a16="http://schemas.microsoft.com/office/drawing/2014/main" xmlns="" id="{DBC34672-EB4E-289B-4C44-6AE8A70C3B9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63005303"/>
                </p:ext>
              </p:extLst>
            </p:nvPr>
          </p:nvGraphicFramePr>
          <p:xfrm>
            <a:off x="6198370" y="-70785"/>
            <a:ext cx="2720583" cy="236854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5" name="Chart 4">
              <a:extLst>
                <a:ext uri="{FF2B5EF4-FFF2-40B4-BE49-F238E27FC236}">
                  <a16:creationId xmlns:a16="http://schemas.microsoft.com/office/drawing/2014/main" xmlns="" id="{ACAC9DF9-0DA3-24D5-D542-4A0C042DDA0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630750554"/>
                </p:ext>
              </p:extLst>
            </p:nvPr>
          </p:nvGraphicFramePr>
          <p:xfrm>
            <a:off x="6346793" y="2158496"/>
            <a:ext cx="2712875" cy="236854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6" name="Chart 5">
              <a:extLst>
                <a:ext uri="{FF2B5EF4-FFF2-40B4-BE49-F238E27FC236}">
                  <a16:creationId xmlns:a16="http://schemas.microsoft.com/office/drawing/2014/main" xmlns="" id="{DA9A1036-00A4-E1E8-3769-E48C7130F565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845875333"/>
                </p:ext>
              </p:extLst>
            </p:nvPr>
          </p:nvGraphicFramePr>
          <p:xfrm>
            <a:off x="354323" y="2280645"/>
            <a:ext cx="2720583" cy="236855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7" name="Chart 6">
              <a:extLst>
                <a:ext uri="{FF2B5EF4-FFF2-40B4-BE49-F238E27FC236}">
                  <a16:creationId xmlns:a16="http://schemas.microsoft.com/office/drawing/2014/main" xmlns="" id="{19604B28-0E26-C3B9-119B-73357EA15BC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35342928"/>
                </p:ext>
              </p:extLst>
            </p:nvPr>
          </p:nvGraphicFramePr>
          <p:xfrm>
            <a:off x="318766" y="4489451"/>
            <a:ext cx="2720583" cy="236854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aphicFrame>
          <p:nvGraphicFramePr>
            <p:cNvPr id="8" name="Chart 7">
              <a:extLst>
                <a:ext uri="{FF2B5EF4-FFF2-40B4-BE49-F238E27FC236}">
                  <a16:creationId xmlns:a16="http://schemas.microsoft.com/office/drawing/2014/main" xmlns="" id="{FD49C21F-CE9A-179E-0D6F-DF2D29CB383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432503933"/>
                </p:ext>
              </p:extLst>
            </p:nvPr>
          </p:nvGraphicFramePr>
          <p:xfrm>
            <a:off x="3271612" y="-28573"/>
            <a:ext cx="2720583" cy="236854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graphicFrame>
          <p:nvGraphicFramePr>
            <p:cNvPr id="9" name="Chart 8">
              <a:extLst>
                <a:ext uri="{FF2B5EF4-FFF2-40B4-BE49-F238E27FC236}">
                  <a16:creationId xmlns:a16="http://schemas.microsoft.com/office/drawing/2014/main" xmlns="" id="{97FAD628-5707-B84A-4260-C6D33C9A369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9563662"/>
                </p:ext>
              </p:extLst>
            </p:nvPr>
          </p:nvGraphicFramePr>
          <p:xfrm>
            <a:off x="3124626" y="2125249"/>
            <a:ext cx="2720583" cy="236855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graphicFrame>
          <p:nvGraphicFramePr>
            <p:cNvPr id="10" name="Chart 9">
              <a:extLst>
                <a:ext uri="{FF2B5EF4-FFF2-40B4-BE49-F238E27FC236}">
                  <a16:creationId xmlns:a16="http://schemas.microsoft.com/office/drawing/2014/main" xmlns="" id="{9B13D21C-DAA6-0E26-CB4F-D4DA5CC0966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290244113"/>
                </p:ext>
              </p:extLst>
            </p:nvPr>
          </p:nvGraphicFramePr>
          <p:xfrm>
            <a:off x="3163994" y="4422908"/>
            <a:ext cx="2720583" cy="236854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graphicFrame>
          <p:nvGraphicFramePr>
            <p:cNvPr id="11" name="Chart 10">
              <a:extLst>
                <a:ext uri="{FF2B5EF4-FFF2-40B4-BE49-F238E27FC236}">
                  <a16:creationId xmlns:a16="http://schemas.microsoft.com/office/drawing/2014/main" xmlns="" id="{EE3229FA-DCE5-36D0-E3F3-273A8EE3E93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147867468"/>
                </p:ext>
              </p:extLst>
            </p:nvPr>
          </p:nvGraphicFramePr>
          <p:xfrm>
            <a:off x="6465693" y="4422908"/>
            <a:ext cx="2593975" cy="236854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1"/>
            </a:graphicData>
          </a:graphic>
        </p:graphicFrame>
      </p:grpSp>
      <p:sp>
        <p:nvSpPr>
          <p:cNvPr id="13" name="TextBox 12"/>
          <p:cNvSpPr txBox="1"/>
          <p:nvPr/>
        </p:nvSpPr>
        <p:spPr>
          <a:xfrm>
            <a:off x="135082" y="0"/>
            <a:ext cx="39069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/>
              <a:t> S Figure 3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229726745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xmlns="" id="{51092449-D7E7-3E84-093F-C07B41C3E0C1}"/>
              </a:ext>
            </a:extLst>
          </p:cNvPr>
          <p:cNvGrpSpPr/>
          <p:nvPr/>
        </p:nvGrpSpPr>
        <p:grpSpPr>
          <a:xfrm>
            <a:off x="935877" y="263728"/>
            <a:ext cx="9840629" cy="6614592"/>
            <a:chOff x="894781" y="379569"/>
            <a:chExt cx="9840629" cy="6614592"/>
          </a:xfrm>
        </p:grpSpPr>
        <p:graphicFrame>
          <p:nvGraphicFramePr>
            <p:cNvPr id="3" name="Chart 2">
              <a:extLst>
                <a:ext uri="{FF2B5EF4-FFF2-40B4-BE49-F238E27FC236}">
                  <a16:creationId xmlns:a16="http://schemas.microsoft.com/office/drawing/2014/main" xmlns="" id="{7A5152EE-DA31-7C78-4632-CF5150428ADA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1055394" y="379569"/>
            <a:ext cx="4722200" cy="353897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xmlns="" id="{E2FEEE85-1E8B-8960-E406-BAA4CF5B512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2594972" y="2883304"/>
              <a:ext cx="1321818" cy="47222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graphicFrame>
          <p:nvGraphicFramePr>
            <p:cNvPr id="5" name="Chart 4">
              <a:extLst>
                <a:ext uri="{FF2B5EF4-FFF2-40B4-BE49-F238E27FC236}">
                  <a16:creationId xmlns:a16="http://schemas.microsoft.com/office/drawing/2014/main" xmlns="" id="{88B6482B-DE0D-1EB8-6C7C-C87172DFB4EF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5819481" y="379570"/>
            <a:ext cx="4915929" cy="353897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6" name="Chart 5">
              <a:extLst>
                <a:ext uri="{FF2B5EF4-FFF2-40B4-BE49-F238E27FC236}">
                  <a16:creationId xmlns:a16="http://schemas.microsoft.com/office/drawing/2014/main" xmlns="" id="{50407D98-3277-4BC2-FD63-C4BA604ED7B6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6125940" y="4005489"/>
            <a:ext cx="4538350" cy="298867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7" name="TextBox 6">
              <a:extLst>
                <a:ext uri="{FF2B5EF4-FFF2-40B4-BE49-F238E27FC236}">
                  <a16:creationId xmlns:a16="http://schemas.microsoft.com/office/drawing/2014/main" xmlns="" id="{B331F5B7-6074-F5E2-0086-13AF14B5D60F}"/>
                </a:ext>
              </a:extLst>
            </p:cNvPr>
            <p:cNvSpPr txBox="1"/>
            <p:nvPr/>
          </p:nvSpPr>
          <p:spPr>
            <a:xfrm>
              <a:off x="1530849" y="5917979"/>
              <a:ext cx="145893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endParaRPr lang="en-GB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xmlns="" id="{AA34DB15-C8B2-217F-14FF-5B7D46920605}"/>
                </a:ext>
              </a:extLst>
            </p:cNvPr>
            <p:cNvSpPr txBox="1"/>
            <p:nvPr/>
          </p:nvSpPr>
          <p:spPr>
            <a:xfrm>
              <a:off x="4377088" y="5917979"/>
              <a:ext cx="145893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M</a:t>
              </a:r>
              <a:endParaRPr lang="en-GB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xmlns="" id="{C9E61992-2FFF-24A1-69F4-53AEC5F7159D}"/>
                </a:ext>
              </a:extLst>
            </p:cNvPr>
            <p:cNvSpPr txBox="1"/>
            <p:nvPr/>
          </p:nvSpPr>
          <p:spPr>
            <a:xfrm>
              <a:off x="3067191" y="5917979"/>
              <a:ext cx="145893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M</a:t>
              </a:r>
              <a:endParaRPr lang="en-GB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xmlns="" id="{0F560CF8-702B-A788-9656-238477455489}"/>
              </a:ext>
            </a:extLst>
          </p:cNvPr>
          <p:cNvGrpSpPr/>
          <p:nvPr/>
        </p:nvGrpSpPr>
        <p:grpSpPr>
          <a:xfrm>
            <a:off x="7294880" y="4003040"/>
            <a:ext cx="2448560" cy="1198880"/>
            <a:chOff x="7294880" y="4003040"/>
            <a:chExt cx="2448560" cy="1198880"/>
          </a:xfrm>
        </p:grpSpPr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xmlns="" id="{1AB24EBD-E336-5C41-CCB0-04C2D5665D1F}"/>
                </a:ext>
              </a:extLst>
            </p:cNvPr>
            <p:cNvCxnSpPr/>
            <p:nvPr/>
          </p:nvCxnSpPr>
          <p:spPr>
            <a:xfrm flipV="1">
              <a:off x="7294880" y="4003040"/>
              <a:ext cx="0" cy="1625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xmlns="" id="{DCA486FF-E2AF-D3EA-53B7-228E32F9EA6E}"/>
                </a:ext>
              </a:extLst>
            </p:cNvPr>
            <p:cNvCxnSpPr>
              <a:cxnSpLocks/>
            </p:cNvCxnSpPr>
            <p:nvPr/>
          </p:nvCxnSpPr>
          <p:spPr>
            <a:xfrm>
              <a:off x="7294880" y="4003040"/>
              <a:ext cx="244856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xmlns="" id="{3B90A19E-6284-FF9D-28F8-BF47BBFF0BC8}"/>
                </a:ext>
              </a:extLst>
            </p:cNvPr>
            <p:cNvCxnSpPr>
              <a:cxnSpLocks/>
            </p:cNvCxnSpPr>
            <p:nvPr/>
          </p:nvCxnSpPr>
          <p:spPr>
            <a:xfrm>
              <a:off x="9743440" y="4003040"/>
              <a:ext cx="0" cy="11988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9CCD34D4-BCA1-7D90-1DDE-FC51D9B7F143}"/>
              </a:ext>
            </a:extLst>
          </p:cNvPr>
          <p:cNvSpPr txBox="1"/>
          <p:nvPr/>
        </p:nvSpPr>
        <p:spPr>
          <a:xfrm>
            <a:off x="8268039" y="3796268"/>
            <a:ext cx="8613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591763AF-9684-1F96-B796-6AB403F47673}"/>
              </a:ext>
            </a:extLst>
          </p:cNvPr>
          <p:cNvSpPr txBox="1"/>
          <p:nvPr/>
        </p:nvSpPr>
        <p:spPr>
          <a:xfrm>
            <a:off x="409308" y="107654"/>
            <a:ext cx="2983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GB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CB5770CF-E435-B81C-5320-E84079E1688F}"/>
              </a:ext>
            </a:extLst>
          </p:cNvPr>
          <p:cNvSpPr txBox="1"/>
          <p:nvPr/>
        </p:nvSpPr>
        <p:spPr>
          <a:xfrm>
            <a:off x="5678288" y="3679179"/>
            <a:ext cx="2983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GB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140EBE69-FAF6-BE17-955B-C5E0E52B1968}"/>
              </a:ext>
            </a:extLst>
          </p:cNvPr>
          <p:cNvSpPr txBox="1"/>
          <p:nvPr/>
        </p:nvSpPr>
        <p:spPr>
          <a:xfrm>
            <a:off x="509579" y="3677467"/>
            <a:ext cx="2983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GB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C8E12D8B-3891-42DB-E921-17ADE3A42FE6}"/>
              </a:ext>
            </a:extLst>
          </p:cNvPr>
          <p:cNvSpPr txBox="1"/>
          <p:nvPr/>
        </p:nvSpPr>
        <p:spPr>
          <a:xfrm>
            <a:off x="5946808" y="7505"/>
            <a:ext cx="2983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GB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652155" y="0"/>
            <a:ext cx="39069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/>
              <a:t>S Figure 4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352446397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xmlns="" id="{8ADC8988-FF60-DB18-1450-D16667BF8693}"/>
              </a:ext>
            </a:extLst>
          </p:cNvPr>
          <p:cNvGrpSpPr/>
          <p:nvPr/>
        </p:nvGrpSpPr>
        <p:grpSpPr>
          <a:xfrm>
            <a:off x="2983228" y="314325"/>
            <a:ext cx="5810839" cy="6460133"/>
            <a:chOff x="2994114" y="314325"/>
            <a:chExt cx="4910137" cy="5458788"/>
          </a:xfrm>
        </p:grpSpPr>
        <p:graphicFrame>
          <p:nvGraphicFramePr>
            <p:cNvPr id="2" name="Chart 1">
              <a:extLst>
                <a:ext uri="{FF2B5EF4-FFF2-40B4-BE49-F238E27FC236}">
                  <a16:creationId xmlns:a16="http://schemas.microsoft.com/office/drawing/2014/main" xmlns="" id="{A680E2E8-91E2-DC86-7D96-234E9D58AF60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2994114" y="314325"/>
            <a:ext cx="2359025" cy="2514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3" name="Chart 2">
              <a:extLst>
                <a:ext uri="{FF2B5EF4-FFF2-40B4-BE49-F238E27FC236}">
                  <a16:creationId xmlns:a16="http://schemas.microsoft.com/office/drawing/2014/main" xmlns="" id="{FE588DC6-6389-693C-2C54-36D5101BC06E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5470614" y="332554"/>
            <a:ext cx="2308225" cy="250825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4" name="Chart 3">
              <a:extLst>
                <a:ext uri="{FF2B5EF4-FFF2-40B4-BE49-F238E27FC236}">
                  <a16:creationId xmlns:a16="http://schemas.microsoft.com/office/drawing/2014/main" xmlns="" id="{B9A47F9D-5ADB-144E-20DC-64A50FA7107F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2994114" y="3214063"/>
            <a:ext cx="2409825" cy="254635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5" name="Chart 4">
              <a:extLst>
                <a:ext uri="{FF2B5EF4-FFF2-40B4-BE49-F238E27FC236}">
                  <a16:creationId xmlns:a16="http://schemas.microsoft.com/office/drawing/2014/main" xmlns="" id="{98D86F29-2559-BEC7-3D08-098E3AB4F51D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5469026" y="3220413"/>
            <a:ext cx="2435225" cy="25527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</p:grpSp>
      <p:sp>
        <p:nvSpPr>
          <p:cNvPr id="7" name="TextBox 6"/>
          <p:cNvSpPr txBox="1"/>
          <p:nvPr/>
        </p:nvSpPr>
        <p:spPr>
          <a:xfrm>
            <a:off x="613064" y="124691"/>
            <a:ext cx="39069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/>
              <a:t>S Figure 5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95429541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8537794B-F7E8-83B4-18FC-1C91A9B4D40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43200" y="144378"/>
            <a:ext cx="6619679" cy="663612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623454" y="0"/>
            <a:ext cx="15794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/>
              <a:t>S Table 1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55374456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xmlns="" id="{FFFFA297-2233-A632-4EF5-5E2625F19560}"/>
              </a:ext>
            </a:extLst>
          </p:cNvPr>
          <p:cNvGraphicFramePr>
            <a:graphicFrameLocks noGrp="1"/>
          </p:cNvGraphicFramePr>
          <p:nvPr/>
        </p:nvGraphicFramePr>
        <p:xfrm>
          <a:off x="554803" y="667819"/>
          <a:ext cx="11476775" cy="6095286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2836537">
                  <a:extLst>
                    <a:ext uri="{9D8B030D-6E8A-4147-A177-3AD203B41FA5}">
                      <a16:colId xmlns:a16="http://schemas.microsoft.com/office/drawing/2014/main" xmlns="" val="1967625588"/>
                    </a:ext>
                  </a:extLst>
                </a:gridCol>
                <a:gridCol w="1548899">
                  <a:extLst>
                    <a:ext uri="{9D8B030D-6E8A-4147-A177-3AD203B41FA5}">
                      <a16:colId xmlns:a16="http://schemas.microsoft.com/office/drawing/2014/main" xmlns="" val="2069622124"/>
                    </a:ext>
                  </a:extLst>
                </a:gridCol>
                <a:gridCol w="1828819">
                  <a:extLst>
                    <a:ext uri="{9D8B030D-6E8A-4147-A177-3AD203B41FA5}">
                      <a16:colId xmlns:a16="http://schemas.microsoft.com/office/drawing/2014/main" xmlns="" val="2987892226"/>
                    </a:ext>
                  </a:extLst>
                </a:gridCol>
                <a:gridCol w="2631260">
                  <a:extLst>
                    <a:ext uri="{9D8B030D-6E8A-4147-A177-3AD203B41FA5}">
                      <a16:colId xmlns:a16="http://schemas.microsoft.com/office/drawing/2014/main" xmlns="" val="1279013432"/>
                    </a:ext>
                  </a:extLst>
                </a:gridCol>
                <a:gridCol w="2631260">
                  <a:extLst>
                    <a:ext uri="{9D8B030D-6E8A-4147-A177-3AD203B41FA5}">
                      <a16:colId xmlns:a16="http://schemas.microsoft.com/office/drawing/2014/main" xmlns="" val="1710174681"/>
                    </a:ext>
                  </a:extLst>
                </a:gridCol>
              </a:tblGrid>
              <a:tr h="23382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 IDs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s</a:t>
                      </a:r>
                      <a:endParaRPr lang="en-GB" sz="16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g2fold change</a:t>
                      </a:r>
                      <a:endParaRPr lang="en-GB" sz="16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PKM values of control 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PKM values of treated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173488528"/>
                  </a:ext>
                </a:extLst>
              </a:tr>
              <a:tr h="2338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12221_c0_g1_i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oroplast Tidi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67202923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7551355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8.287628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extLst>
                  <a:ext uri="{0D108BD9-81ED-4DB2-BD59-A6C34878D82A}">
                    <a16:rowId xmlns:a16="http://schemas.microsoft.com/office/drawing/2014/main" xmlns="" val="96664393"/>
                  </a:ext>
                </a:extLst>
              </a:tr>
              <a:tr h="2338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1444_c0_g1_i22</a:t>
                      </a:r>
                      <a:endParaRPr lang="en-US" sz="1200" b="0" i="0" u="none" strike="noStrike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hcb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81.816475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90.34209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extLst>
                  <a:ext uri="{0D108BD9-81ED-4DB2-BD59-A6C34878D82A}">
                    <a16:rowId xmlns:a16="http://schemas.microsoft.com/office/drawing/2014/main" xmlns="" val="1824197519"/>
                  </a:ext>
                </a:extLst>
              </a:tr>
              <a:tr h="2338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2123_c0_g1_i8</a:t>
                      </a:r>
                      <a:endParaRPr lang="en-US" sz="1200" b="0" i="0" u="none" strike="noStrike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b2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2668084</a:t>
                      </a:r>
                      <a:endParaRPr lang="en-GB" sz="1200" b="0" i="0" u="none" strike="noStrike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3923658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.3233380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extLst>
                  <a:ext uri="{0D108BD9-81ED-4DB2-BD59-A6C34878D82A}">
                    <a16:rowId xmlns:a16="http://schemas.microsoft.com/office/drawing/2014/main" xmlns="" val="3955845080"/>
                  </a:ext>
                </a:extLst>
              </a:tr>
              <a:tr h="2338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2037_c0_g1_i6</a:t>
                      </a:r>
                      <a:endParaRPr lang="en-US" sz="1200" b="0" i="0" u="none" strike="noStrike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b2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93403242</a:t>
                      </a:r>
                      <a:endParaRPr lang="en-GB" sz="1200" b="0" i="0" u="none" strike="noStrike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1.580848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1.710202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extLst>
                  <a:ext uri="{0D108BD9-81ED-4DB2-BD59-A6C34878D82A}">
                    <a16:rowId xmlns:a16="http://schemas.microsoft.com/office/drawing/2014/main" xmlns="" val="2933939655"/>
                  </a:ext>
                </a:extLst>
              </a:tr>
              <a:tr h="2338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32629_c0_g1_i1</a:t>
                      </a:r>
                      <a:endParaRPr lang="en-US" sz="1200" b="0" i="0" u="none" strike="noStrike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hcII type I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49451135</a:t>
                      </a:r>
                      <a:endParaRPr lang="en-GB" sz="1200" b="0" i="0" u="none" strike="noStrike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.2219514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2.3009559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extLst>
                  <a:ext uri="{0D108BD9-81ED-4DB2-BD59-A6C34878D82A}">
                    <a16:rowId xmlns:a16="http://schemas.microsoft.com/office/drawing/2014/main" xmlns="" val="2633569652"/>
                  </a:ext>
                </a:extLst>
              </a:tr>
              <a:tr h="2338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5262_c0_g1_i21</a:t>
                      </a:r>
                      <a:endParaRPr lang="en-US" sz="1200" b="0" i="0" u="none" strike="noStrike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bQ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9</a:t>
                      </a:r>
                      <a:endParaRPr lang="en-GB" sz="1200" b="0" i="0" u="none" strike="noStrike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84.599370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66.23335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extLst>
                  <a:ext uri="{0D108BD9-81ED-4DB2-BD59-A6C34878D82A}">
                    <a16:rowId xmlns:a16="http://schemas.microsoft.com/office/drawing/2014/main" xmlns="" val="949205374"/>
                  </a:ext>
                </a:extLst>
              </a:tr>
              <a:tr h="2338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7535_c0_g1_i1</a:t>
                      </a:r>
                      <a:endParaRPr lang="en-US" sz="1200" b="0" i="0" u="none" strike="noStrike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bZ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99199091</a:t>
                      </a:r>
                      <a:endParaRPr lang="en-GB" sz="1200" b="0" i="0" u="none" strike="noStrike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72455893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5247354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extLst>
                  <a:ext uri="{0D108BD9-81ED-4DB2-BD59-A6C34878D82A}">
                    <a16:rowId xmlns:a16="http://schemas.microsoft.com/office/drawing/2014/main" xmlns="" val="614864472"/>
                  </a:ext>
                </a:extLst>
              </a:tr>
              <a:tr h="2338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46373_c0_g1_i11</a:t>
                      </a:r>
                      <a:endParaRPr lang="en-US" sz="1200" b="0" i="0" u="none" strike="noStrike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bF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84420985</a:t>
                      </a:r>
                      <a:endParaRPr lang="en-GB" sz="1200" b="0" i="0" u="none" strike="noStrike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38925046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6012828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extLst>
                  <a:ext uri="{0D108BD9-81ED-4DB2-BD59-A6C34878D82A}">
                    <a16:rowId xmlns:a16="http://schemas.microsoft.com/office/drawing/2014/main" xmlns="" val="1791705771"/>
                  </a:ext>
                </a:extLst>
              </a:tr>
              <a:tr h="2338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40757_c0_g3_i1</a:t>
                      </a:r>
                      <a:endParaRPr lang="en-US" sz="1200" b="0" i="0" u="none" strike="noStrike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bT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38198628</a:t>
                      </a:r>
                      <a:endParaRPr lang="en-GB" sz="1200" b="0" i="0" u="none" strike="noStrike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.6289829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.467384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extLst>
                  <a:ext uri="{0D108BD9-81ED-4DB2-BD59-A6C34878D82A}">
                    <a16:rowId xmlns:a16="http://schemas.microsoft.com/office/drawing/2014/main" xmlns="" val="3528909473"/>
                  </a:ext>
                </a:extLst>
              </a:tr>
              <a:tr h="2338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1940_c1_g1_i1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hca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643107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8.913567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81.404571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extLst>
                  <a:ext uri="{0D108BD9-81ED-4DB2-BD59-A6C34878D82A}">
                    <a16:rowId xmlns:a16="http://schemas.microsoft.com/office/drawing/2014/main" xmlns="" val="2453025688"/>
                  </a:ext>
                </a:extLst>
              </a:tr>
              <a:tr h="2338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8802_c0_g1_i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bP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3043376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.5555845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0.99471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extLst>
                  <a:ext uri="{0D108BD9-81ED-4DB2-BD59-A6C34878D82A}">
                    <a16:rowId xmlns:a16="http://schemas.microsoft.com/office/drawing/2014/main" xmlns="" val="3124817994"/>
                  </a:ext>
                </a:extLst>
              </a:tr>
              <a:tr h="2338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40757_c0_g1_i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bB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4694623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.4309141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.1400142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extLst>
                  <a:ext uri="{0D108BD9-81ED-4DB2-BD59-A6C34878D82A}">
                    <a16:rowId xmlns:a16="http://schemas.microsoft.com/office/drawing/2014/main" xmlns="" val="416884097"/>
                  </a:ext>
                </a:extLst>
              </a:tr>
              <a:tr h="2338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3046_c0_g1_i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tB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3745367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.38424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.1263830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extLst>
                  <a:ext uri="{0D108BD9-81ED-4DB2-BD59-A6C34878D82A}">
                    <a16:rowId xmlns:a16="http://schemas.microsoft.com/office/drawing/2014/main" xmlns="" val="3519797592"/>
                  </a:ext>
                </a:extLst>
              </a:tr>
              <a:tr h="2338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3207_c1_g1_i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hcb2.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2872905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.0559002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8.4663857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extLst>
                  <a:ext uri="{0D108BD9-81ED-4DB2-BD59-A6C34878D82A}">
                    <a16:rowId xmlns:a16="http://schemas.microsoft.com/office/drawing/2014/main" xmlns="" val="2826415973"/>
                  </a:ext>
                </a:extLst>
              </a:tr>
              <a:tr h="2338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1444_c0_g1_i1</a:t>
                      </a:r>
                      <a:endParaRPr lang="en-US" sz="1200" b="0" i="0" u="none" strike="noStrike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hcb2.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1215976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42.86627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193.28010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extLst>
                  <a:ext uri="{0D108BD9-81ED-4DB2-BD59-A6C34878D82A}">
                    <a16:rowId xmlns:a16="http://schemas.microsoft.com/office/drawing/2014/main" xmlns="" val="4177231133"/>
                  </a:ext>
                </a:extLst>
              </a:tr>
              <a:tr h="2338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330_c2_g3_i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hca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3333832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1.469806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7.922048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extLst>
                  <a:ext uri="{0D108BD9-81ED-4DB2-BD59-A6C34878D82A}">
                    <a16:rowId xmlns:a16="http://schemas.microsoft.com/office/drawing/2014/main" xmlns="" val="1155664098"/>
                  </a:ext>
                </a:extLst>
              </a:tr>
              <a:tr h="2338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5050_c0_g3_i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aB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5610436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68.217565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78.42344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extLst>
                  <a:ext uri="{0D108BD9-81ED-4DB2-BD59-A6C34878D82A}">
                    <a16:rowId xmlns:a16="http://schemas.microsoft.com/office/drawing/2014/main" xmlns="" val="3085653259"/>
                  </a:ext>
                </a:extLst>
              </a:tr>
              <a:tr h="2338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11116_c0_g2_i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bC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8465914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.1691450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6.8576854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extLst>
                  <a:ext uri="{0D108BD9-81ED-4DB2-BD59-A6C34878D82A}">
                    <a16:rowId xmlns:a16="http://schemas.microsoft.com/office/drawing/2014/main" xmlns="" val="469992794"/>
                  </a:ext>
                </a:extLst>
              </a:tr>
              <a:tr h="2338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1183_c0_g1_i3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p2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6107475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2.688218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5.654762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extLst>
                  <a:ext uri="{0D108BD9-81ED-4DB2-BD59-A6C34878D82A}">
                    <a16:rowId xmlns:a16="http://schemas.microsoft.com/office/drawing/2014/main" xmlns="" val="1725993042"/>
                  </a:ext>
                </a:extLst>
              </a:tr>
              <a:tr h="2338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11257_c0_g2_i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aF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9541400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46.89154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30.56467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extLst>
                  <a:ext uri="{0D108BD9-81ED-4DB2-BD59-A6C34878D82A}">
                    <a16:rowId xmlns:a16="http://schemas.microsoft.com/office/drawing/2014/main" xmlns="" val="2754362001"/>
                  </a:ext>
                </a:extLst>
              </a:tr>
              <a:tr h="2338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22062_c0_g1_i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tA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2579006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64.88237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18.87587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extLst>
                  <a:ext uri="{0D108BD9-81ED-4DB2-BD59-A6C34878D82A}">
                    <a16:rowId xmlns:a16="http://schemas.microsoft.com/office/drawing/2014/main" xmlns="" val="2438842915"/>
                  </a:ext>
                </a:extLst>
              </a:tr>
              <a:tr h="2338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11257_c0_g2_i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bW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47565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68.415012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32.42701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extLst>
                  <a:ext uri="{0D108BD9-81ED-4DB2-BD59-A6C34878D82A}">
                    <a16:rowId xmlns:a16="http://schemas.microsoft.com/office/drawing/2014/main" xmlns="" val="2671260283"/>
                  </a:ext>
                </a:extLst>
              </a:tr>
              <a:tr h="2338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40757_c0_g3_i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bT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3819862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.6289829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.467384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extLst>
                  <a:ext uri="{0D108BD9-81ED-4DB2-BD59-A6C34878D82A}">
                    <a16:rowId xmlns:a16="http://schemas.microsoft.com/office/drawing/2014/main" xmlns="" val="332279166"/>
                  </a:ext>
                </a:extLst>
              </a:tr>
              <a:tr h="2338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2767_c0_g2_i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N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69513088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.2214030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.1414101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extLst>
                  <a:ext uri="{0D108BD9-81ED-4DB2-BD59-A6C34878D82A}">
                    <a16:rowId xmlns:a16="http://schemas.microsoft.com/office/drawing/2014/main" xmlns="" val="2616747462"/>
                  </a:ext>
                </a:extLst>
              </a:tr>
              <a:tr h="2338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9262_c0_g1_i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br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99262414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72521915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.32201688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771" marR="5771" marT="5771" marB="0" anchor="b"/>
                </a:tc>
                <a:extLst>
                  <a:ext uri="{0D108BD9-81ED-4DB2-BD59-A6C34878D82A}">
                    <a16:rowId xmlns:a16="http://schemas.microsoft.com/office/drawing/2014/main" xmlns="" val="1553790551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67391EF9-1CAA-E1C1-A37D-45858F73A62D}"/>
              </a:ext>
            </a:extLst>
          </p:cNvPr>
          <p:cNvSpPr txBox="1"/>
          <p:nvPr/>
        </p:nvSpPr>
        <p:spPr>
          <a:xfrm>
            <a:off x="482044" y="232344"/>
            <a:ext cx="2983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GB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23454" y="0"/>
            <a:ext cx="15794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/>
              <a:t>S Table 2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213494576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xmlns="" id="{558A0350-E68F-7CBA-6868-42F868B8E762}"/>
              </a:ext>
            </a:extLst>
          </p:cNvPr>
          <p:cNvGraphicFramePr>
            <a:graphicFrameLocks noGrp="1"/>
          </p:cNvGraphicFramePr>
          <p:nvPr/>
        </p:nvGraphicFramePr>
        <p:xfrm>
          <a:off x="595901" y="626723"/>
          <a:ext cx="11358678" cy="5783705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3294883">
                  <a:extLst>
                    <a:ext uri="{9D8B030D-6E8A-4147-A177-3AD203B41FA5}">
                      <a16:colId xmlns:a16="http://schemas.microsoft.com/office/drawing/2014/main" xmlns="" val="1470217312"/>
                    </a:ext>
                  </a:extLst>
                </a:gridCol>
                <a:gridCol w="1712473">
                  <a:extLst>
                    <a:ext uri="{9D8B030D-6E8A-4147-A177-3AD203B41FA5}">
                      <a16:colId xmlns:a16="http://schemas.microsoft.com/office/drawing/2014/main" xmlns="" val="225605244"/>
                    </a:ext>
                  </a:extLst>
                </a:gridCol>
                <a:gridCol w="2327267">
                  <a:extLst>
                    <a:ext uri="{9D8B030D-6E8A-4147-A177-3AD203B41FA5}">
                      <a16:colId xmlns:a16="http://schemas.microsoft.com/office/drawing/2014/main" xmlns="" val="1288447208"/>
                    </a:ext>
                  </a:extLst>
                </a:gridCol>
                <a:gridCol w="2444874">
                  <a:extLst>
                    <a:ext uri="{9D8B030D-6E8A-4147-A177-3AD203B41FA5}">
                      <a16:colId xmlns:a16="http://schemas.microsoft.com/office/drawing/2014/main" xmlns="" val="2481416515"/>
                    </a:ext>
                  </a:extLst>
                </a:gridCol>
                <a:gridCol w="1579181">
                  <a:extLst>
                    <a:ext uri="{9D8B030D-6E8A-4147-A177-3AD203B41FA5}">
                      <a16:colId xmlns:a16="http://schemas.microsoft.com/office/drawing/2014/main" xmlns="" val="3402066632"/>
                    </a:ext>
                  </a:extLst>
                </a:gridCol>
              </a:tblGrid>
              <a:tr h="46946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 IDs</a:t>
                      </a:r>
                      <a:endParaRPr lang="en-GB" sz="16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s</a:t>
                      </a:r>
                      <a:endParaRPr lang="en-GB" sz="16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PKM values of control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PKM values of treated</a:t>
                      </a:r>
                      <a:endParaRPr lang="en-GB" sz="16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g2fold change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343091336"/>
                  </a:ext>
                </a:extLst>
              </a:tr>
              <a:tr h="25305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4937_c1_g1_i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SOD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361638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3.56266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53654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xmlns="" val="2394393857"/>
                  </a:ext>
                </a:extLst>
              </a:tr>
              <a:tr h="25305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8693_c0_g1_i2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X-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8.114515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1.823204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6707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xmlns="" val="498390308"/>
                  </a:ext>
                </a:extLst>
              </a:tr>
              <a:tr h="25305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3502_c0_g1_i12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X-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9.6882544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9.437071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802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xmlns="" val="474243593"/>
                  </a:ext>
                </a:extLst>
              </a:tr>
              <a:tr h="25305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16267_c0_g1_i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PX 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0.97412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1.078306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9760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xmlns="" val="2989382253"/>
                  </a:ext>
                </a:extLst>
              </a:tr>
              <a:tr h="25305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3117_c0_g2_i1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 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484952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6140869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72536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xmlns="" val="1530635155"/>
                  </a:ext>
                </a:extLst>
              </a:tr>
              <a:tr h="25305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6033_c0_g2_i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8393586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3316625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1549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xmlns="" val="187752327"/>
                  </a:ext>
                </a:extLst>
              </a:tr>
              <a:tr h="25305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11514_c0_g1_i2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ST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6357660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70049546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581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xmlns="" val="3279331367"/>
                  </a:ext>
                </a:extLst>
              </a:tr>
              <a:tr h="25305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131_c0_g1_i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DHAR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4582180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.5844927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4541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xmlns="" val="864354816"/>
                  </a:ext>
                </a:extLst>
              </a:tr>
              <a:tr h="25305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15413_c0_g2_i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 Cys Prx 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6872794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9201151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055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xmlns="" val="3108303947"/>
                  </a:ext>
                </a:extLst>
              </a:tr>
              <a:tr h="25305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5538_c0_g1_i1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TR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.5874994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8.5080192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4051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xmlns="" val="2601960093"/>
                  </a:ext>
                </a:extLst>
              </a:tr>
              <a:tr h="25305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3117_c0_g1_i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Px-Q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.4049798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8.9892551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7829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xmlns="" val="2174216706"/>
                  </a:ext>
                </a:extLst>
              </a:tr>
              <a:tr h="25305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3993_c0_g1_i2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Px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2120792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1275030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7345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xmlns="" val="3086080852"/>
                  </a:ext>
                </a:extLst>
              </a:tr>
              <a:tr h="25305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990_c0_g1_i2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MSR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85892464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3550764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9974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xmlns="" val="767197516"/>
                  </a:ext>
                </a:extLst>
              </a:tr>
              <a:tr h="25305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2852_c0_g2_i1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XNL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80130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5946313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49990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xmlns="" val="2182942689"/>
                  </a:ext>
                </a:extLst>
              </a:tr>
              <a:tr h="25305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6782_c0_g1_i1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M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9178171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6904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xmlns="" val="2860086028"/>
                  </a:ext>
                </a:extLst>
              </a:tr>
              <a:tr h="25305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878_c0_g2_i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AC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11702542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7954169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326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xmlns="" val="3545879002"/>
                  </a:ext>
                </a:extLst>
              </a:tr>
              <a:tr h="25305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9636_c0_g1_i1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R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3.949827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55.207866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7363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xmlns="" val="2697619923"/>
                  </a:ext>
                </a:extLst>
              </a:tr>
              <a:tr h="25305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4313_c0_g1_i4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PK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.8749310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.2030300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5544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xmlns="" val="1327504126"/>
                  </a:ext>
                </a:extLst>
              </a:tr>
              <a:tr h="25305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1384_c0_g2_i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-FLP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952122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02761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xmlns="" val="1859875162"/>
                  </a:ext>
                </a:extLst>
              </a:tr>
              <a:tr h="25305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502_c0_g2_i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D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6.1961289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1.672419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7558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xmlns="" val="3557292839"/>
                  </a:ext>
                </a:extLst>
              </a:tr>
              <a:tr h="25305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NITY_DN20681_c0_g1_i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MOX 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868687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4340872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043851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xmlns="" val="3673730167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3E5846F8-8B57-C6B1-24CB-F6607555A33B}"/>
              </a:ext>
            </a:extLst>
          </p:cNvPr>
          <p:cNvSpPr txBox="1"/>
          <p:nvPr/>
        </p:nvSpPr>
        <p:spPr>
          <a:xfrm>
            <a:off x="409308" y="107654"/>
            <a:ext cx="2983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GB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623454" y="0"/>
            <a:ext cx="15794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/>
              <a:t>S Table 2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15547521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437</Words>
  <Application>Microsoft Office PowerPoint</Application>
  <PresentationFormat>Widescreen</PresentationFormat>
  <Paragraphs>343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5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vithra R</dc:creator>
  <cp:lastModifiedBy>Microsoft account</cp:lastModifiedBy>
  <cp:revision>3</cp:revision>
  <dcterms:created xsi:type="dcterms:W3CDTF">2023-03-20T12:12:53Z</dcterms:created>
  <dcterms:modified xsi:type="dcterms:W3CDTF">2023-03-20T12:45:46Z</dcterms:modified>
</cp:coreProperties>
</file>